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164" y="-78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jpeg"/><Relationship Id="rId3" Type="http://schemas.openxmlformats.org/officeDocument/2006/relationships/image" Target="../media/image54.jpeg"/><Relationship Id="rId7" Type="http://schemas.openxmlformats.org/officeDocument/2006/relationships/image" Target="../media/image58.jpeg"/><Relationship Id="rId2" Type="http://schemas.openxmlformats.org/officeDocument/2006/relationships/image" Target="../media/image5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7.jpeg"/><Relationship Id="rId5" Type="http://schemas.openxmlformats.org/officeDocument/2006/relationships/image" Target="../media/image56.jpeg"/><Relationship Id="rId10" Type="http://schemas.openxmlformats.org/officeDocument/2006/relationships/image" Target="../media/image45.jpeg"/><Relationship Id="rId4" Type="http://schemas.openxmlformats.org/officeDocument/2006/relationships/image" Target="../media/image55.jpeg"/><Relationship Id="rId9" Type="http://schemas.openxmlformats.org/officeDocument/2006/relationships/image" Target="../media/image60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jpeg"/><Relationship Id="rId2" Type="http://schemas.openxmlformats.org/officeDocument/2006/relationships/image" Target="../media/image6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5.jpeg"/><Relationship Id="rId5" Type="http://schemas.openxmlformats.org/officeDocument/2006/relationships/image" Target="../media/image64.jpeg"/><Relationship Id="rId4" Type="http://schemas.openxmlformats.org/officeDocument/2006/relationships/image" Target="../media/image63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jpeg"/><Relationship Id="rId2" Type="http://schemas.openxmlformats.org/officeDocument/2006/relationships/image" Target="../media/image6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0.jpeg"/><Relationship Id="rId5" Type="http://schemas.openxmlformats.org/officeDocument/2006/relationships/image" Target="../media/image69.jpeg"/><Relationship Id="rId4" Type="http://schemas.openxmlformats.org/officeDocument/2006/relationships/image" Target="../media/image68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2.jpeg"/><Relationship Id="rId7" Type="http://schemas.openxmlformats.org/officeDocument/2006/relationships/image" Target="../media/image75.jpeg"/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jpeg"/><Relationship Id="rId5" Type="http://schemas.openxmlformats.org/officeDocument/2006/relationships/image" Target="../media/image74.jpeg"/><Relationship Id="rId4" Type="http://schemas.openxmlformats.org/officeDocument/2006/relationships/image" Target="../media/image73.jpeg"/></Relationships>
</file>

<file path=ppt/slides/_rels/slide14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85.jpeg"/><Relationship Id="rId3" Type="http://schemas.microsoft.com/office/2007/relationships/hdphoto" Target="../media/hdphoto2.wdp"/><Relationship Id="rId7" Type="http://schemas.openxmlformats.org/officeDocument/2006/relationships/image" Target="../media/image80.jpeg"/><Relationship Id="rId12" Type="http://schemas.openxmlformats.org/officeDocument/2006/relationships/image" Target="../media/image84.jpe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9.jpeg"/><Relationship Id="rId11" Type="http://schemas.openxmlformats.org/officeDocument/2006/relationships/image" Target="../media/image83.jpeg"/><Relationship Id="rId5" Type="http://schemas.openxmlformats.org/officeDocument/2006/relationships/image" Target="../media/image78.jpeg"/><Relationship Id="rId10" Type="http://schemas.openxmlformats.org/officeDocument/2006/relationships/image" Target="../media/image82.jpeg"/><Relationship Id="rId4" Type="http://schemas.openxmlformats.org/officeDocument/2006/relationships/image" Target="../media/image77.jpeg"/><Relationship Id="rId9" Type="http://schemas.openxmlformats.org/officeDocument/2006/relationships/image" Target="../media/image81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jpeg"/><Relationship Id="rId2" Type="http://schemas.openxmlformats.org/officeDocument/2006/relationships/image" Target="../media/image8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0.jpeg"/><Relationship Id="rId5" Type="http://schemas.openxmlformats.org/officeDocument/2006/relationships/image" Target="../media/image89.jpeg"/><Relationship Id="rId4" Type="http://schemas.openxmlformats.org/officeDocument/2006/relationships/image" Target="../media/image88.jpe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2.jpeg"/><Relationship Id="rId7" Type="http://schemas.openxmlformats.org/officeDocument/2006/relationships/image" Target="../media/image96.jpeg"/><Relationship Id="rId2" Type="http://schemas.openxmlformats.org/officeDocument/2006/relationships/image" Target="../media/image9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5.jpeg"/><Relationship Id="rId5" Type="http://schemas.openxmlformats.org/officeDocument/2006/relationships/image" Target="../media/image94.png"/><Relationship Id="rId4" Type="http://schemas.openxmlformats.org/officeDocument/2006/relationships/image" Target="../media/image93.jpe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8.jpeg"/><Relationship Id="rId7" Type="http://schemas.openxmlformats.org/officeDocument/2006/relationships/image" Target="../media/image102.jpeg"/><Relationship Id="rId2" Type="http://schemas.openxmlformats.org/officeDocument/2006/relationships/image" Target="../media/image9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1.jpeg"/><Relationship Id="rId5" Type="http://schemas.openxmlformats.org/officeDocument/2006/relationships/image" Target="../media/image100.jpeg"/><Relationship Id="rId4" Type="http://schemas.openxmlformats.org/officeDocument/2006/relationships/image" Target="../media/image99.jpeg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9.jpeg"/><Relationship Id="rId3" Type="http://schemas.openxmlformats.org/officeDocument/2006/relationships/image" Target="../media/image104.jpeg"/><Relationship Id="rId7" Type="http://schemas.openxmlformats.org/officeDocument/2006/relationships/image" Target="../media/image108.jpeg"/><Relationship Id="rId2" Type="http://schemas.openxmlformats.org/officeDocument/2006/relationships/image" Target="../media/image10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7.jpeg"/><Relationship Id="rId5" Type="http://schemas.openxmlformats.org/officeDocument/2006/relationships/image" Target="../media/image106.jpeg"/><Relationship Id="rId10" Type="http://schemas.openxmlformats.org/officeDocument/2006/relationships/image" Target="../media/image111.jpeg"/><Relationship Id="rId4" Type="http://schemas.openxmlformats.org/officeDocument/2006/relationships/image" Target="../media/image105.jpeg"/><Relationship Id="rId9" Type="http://schemas.openxmlformats.org/officeDocument/2006/relationships/image" Target="../media/image110.jpeg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8.jpeg"/><Relationship Id="rId3" Type="http://schemas.openxmlformats.org/officeDocument/2006/relationships/image" Target="../media/image113.jpeg"/><Relationship Id="rId7" Type="http://schemas.openxmlformats.org/officeDocument/2006/relationships/image" Target="../media/image117.jpeg"/><Relationship Id="rId2" Type="http://schemas.openxmlformats.org/officeDocument/2006/relationships/image" Target="../media/image11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6.jpeg"/><Relationship Id="rId5" Type="http://schemas.openxmlformats.org/officeDocument/2006/relationships/image" Target="../media/image115.jpeg"/><Relationship Id="rId10" Type="http://schemas.openxmlformats.org/officeDocument/2006/relationships/image" Target="../media/image120.jpeg"/><Relationship Id="rId4" Type="http://schemas.openxmlformats.org/officeDocument/2006/relationships/image" Target="../media/image114.jpeg"/><Relationship Id="rId9" Type="http://schemas.openxmlformats.org/officeDocument/2006/relationships/image" Target="../media/image119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7.jpeg"/><Relationship Id="rId13" Type="http://schemas.openxmlformats.org/officeDocument/2006/relationships/image" Target="../media/image132.jpeg"/><Relationship Id="rId3" Type="http://schemas.openxmlformats.org/officeDocument/2006/relationships/image" Target="../media/image122.png"/><Relationship Id="rId7" Type="http://schemas.openxmlformats.org/officeDocument/2006/relationships/image" Target="../media/image126.png"/><Relationship Id="rId12" Type="http://schemas.openxmlformats.org/officeDocument/2006/relationships/image" Target="../media/image131.jpeg"/><Relationship Id="rId2" Type="http://schemas.openxmlformats.org/officeDocument/2006/relationships/image" Target="../media/image12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5.png"/><Relationship Id="rId11" Type="http://schemas.openxmlformats.org/officeDocument/2006/relationships/image" Target="../media/image130.jpeg"/><Relationship Id="rId5" Type="http://schemas.openxmlformats.org/officeDocument/2006/relationships/image" Target="../media/image124.jpeg"/><Relationship Id="rId10" Type="http://schemas.openxmlformats.org/officeDocument/2006/relationships/image" Target="../media/image129.jpeg"/><Relationship Id="rId4" Type="http://schemas.openxmlformats.org/officeDocument/2006/relationships/image" Target="../media/image123.png"/><Relationship Id="rId9" Type="http://schemas.openxmlformats.org/officeDocument/2006/relationships/image" Target="../media/image128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4.jpeg"/><Relationship Id="rId7" Type="http://schemas.openxmlformats.org/officeDocument/2006/relationships/image" Target="../media/image138.png"/><Relationship Id="rId2" Type="http://schemas.openxmlformats.org/officeDocument/2006/relationships/image" Target="../media/image13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7.jpeg"/><Relationship Id="rId5" Type="http://schemas.openxmlformats.org/officeDocument/2006/relationships/image" Target="../media/image136.jpeg"/><Relationship Id="rId4" Type="http://schemas.openxmlformats.org/officeDocument/2006/relationships/image" Target="../media/image135.jpeg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5.jpeg"/><Relationship Id="rId3" Type="http://schemas.openxmlformats.org/officeDocument/2006/relationships/image" Target="../media/image140.jpeg"/><Relationship Id="rId7" Type="http://schemas.openxmlformats.org/officeDocument/2006/relationships/image" Target="../media/image144.jpeg"/><Relationship Id="rId2" Type="http://schemas.openxmlformats.org/officeDocument/2006/relationships/image" Target="../media/image13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3.jpeg"/><Relationship Id="rId5" Type="http://schemas.openxmlformats.org/officeDocument/2006/relationships/image" Target="../media/image142.jpeg"/><Relationship Id="rId4" Type="http://schemas.openxmlformats.org/officeDocument/2006/relationships/image" Target="../media/image141.jpeg"/><Relationship Id="rId9" Type="http://schemas.openxmlformats.org/officeDocument/2006/relationships/image" Target="../media/image146.jpe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15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jpeg"/><Relationship Id="rId4" Type="http://schemas.openxmlformats.org/officeDocument/2006/relationships/image" Target="../media/image18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7" Type="http://schemas.openxmlformats.org/officeDocument/2006/relationships/image" Target="../media/image25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jpeg"/><Relationship Id="rId5" Type="http://schemas.openxmlformats.org/officeDocument/2006/relationships/image" Target="../media/image23.jpeg"/><Relationship Id="rId4" Type="http://schemas.openxmlformats.org/officeDocument/2006/relationships/image" Target="../media/image22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eg"/><Relationship Id="rId7" Type="http://schemas.openxmlformats.org/officeDocument/2006/relationships/image" Target="../media/image31.jpeg"/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jpeg"/><Relationship Id="rId5" Type="http://schemas.openxmlformats.org/officeDocument/2006/relationships/image" Target="../media/image29.jpeg"/><Relationship Id="rId4" Type="http://schemas.openxmlformats.org/officeDocument/2006/relationships/image" Target="../media/image28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eg"/><Relationship Id="rId7" Type="http://schemas.openxmlformats.org/officeDocument/2006/relationships/image" Target="../media/image37.jpeg"/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jpeg"/><Relationship Id="rId5" Type="http://schemas.openxmlformats.org/officeDocument/2006/relationships/image" Target="../media/image35.jpeg"/><Relationship Id="rId4" Type="http://schemas.openxmlformats.org/officeDocument/2006/relationships/image" Target="../media/image34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jpeg"/><Relationship Id="rId7" Type="http://schemas.openxmlformats.org/officeDocument/2006/relationships/image" Target="../media/image43.jpeg"/><Relationship Id="rId2" Type="http://schemas.openxmlformats.org/officeDocument/2006/relationships/image" Target="../media/image3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jpeg"/><Relationship Id="rId5" Type="http://schemas.openxmlformats.org/officeDocument/2006/relationships/image" Target="../media/image41.jpeg"/><Relationship Id="rId4" Type="http://schemas.openxmlformats.org/officeDocument/2006/relationships/image" Target="../media/image40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jpeg"/><Relationship Id="rId3" Type="http://schemas.openxmlformats.org/officeDocument/2006/relationships/image" Target="../media/image45.jpeg"/><Relationship Id="rId7" Type="http://schemas.openxmlformats.org/officeDocument/2006/relationships/image" Target="../media/image49.jpeg"/><Relationship Id="rId2" Type="http://schemas.openxmlformats.org/officeDocument/2006/relationships/image" Target="../media/image4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jpeg"/><Relationship Id="rId5" Type="http://schemas.openxmlformats.org/officeDocument/2006/relationships/image" Target="../media/image47.jpeg"/><Relationship Id="rId10" Type="http://schemas.openxmlformats.org/officeDocument/2006/relationships/image" Target="../media/image52.jpeg"/><Relationship Id="rId4" Type="http://schemas.openxmlformats.org/officeDocument/2006/relationships/image" Target="../media/image46.jpeg"/><Relationship Id="rId9" Type="http://schemas.openxmlformats.org/officeDocument/2006/relationships/image" Target="../media/image5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:\Cytochrome c paper\WB\Amyloid\Pirh2 2.jp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1" y="964565"/>
            <a:ext cx="2362200" cy="2360612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D:\Cytochrome c paper\WB\Amyloid\ptau.jpg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1800" y="1068386"/>
            <a:ext cx="2590800" cy="225679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C:\Users\Acer\Desktop\actin cells.jpg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1522" t="-67818" r="-29910" b="-52267"/>
          <a:stretch/>
        </p:blipFill>
        <p:spPr bwMode="auto">
          <a:xfrm>
            <a:off x="5363569" y="1664731"/>
            <a:ext cx="1774209" cy="914695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D:\Cytochrome c paper\WB\Amyloid\cas 3.jpg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4851" y="2362200"/>
            <a:ext cx="2781300" cy="2638425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 descr="D:\Cytochrome c paper\WB\Amyloid\actin AB.jpg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7000" y="2362200"/>
            <a:ext cx="3276600" cy="2638425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Rectangle 8"/>
          <p:cNvSpPr/>
          <p:nvPr/>
        </p:nvSpPr>
        <p:spPr>
          <a:xfrm>
            <a:off x="304800" y="697468"/>
            <a:ext cx="12897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1 (c) 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1676400" y="1295400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Pirh2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843916" y="1295400"/>
            <a:ext cx="756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</a:t>
            </a:r>
            <a:r>
              <a:rPr lang="en-US" dirty="0" smtClean="0"/>
              <a:t>p-Tau</a:t>
            </a: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5949046" y="1295400"/>
            <a:ext cx="61709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 </a:t>
            </a:r>
            <a:r>
              <a:rPr lang="en-US" dirty="0" smtClean="0"/>
              <a:t>Tau</a:t>
            </a:r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3810000" y="2971800"/>
            <a:ext cx="9444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β-actin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1219200" y="2971800"/>
            <a:ext cx="19595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Cleaved </a:t>
            </a:r>
            <a:r>
              <a:rPr lang="en-US" dirty="0" err="1" smtClean="0"/>
              <a:t>Caspase</a:t>
            </a:r>
            <a:r>
              <a:rPr lang="en-US" dirty="0" smtClean="0"/>
              <a:t> </a:t>
            </a:r>
            <a:r>
              <a:rPr lang="en-US" dirty="0"/>
              <a:t>3 </a:t>
            </a:r>
          </a:p>
        </p:txBody>
      </p:sp>
    </p:spTree>
    <p:extLst>
      <p:ext uri="{BB962C8B-B14F-4D97-AF65-F5344CB8AC3E}">
        <p14:creationId xmlns:p14="http://schemas.microsoft.com/office/powerpoint/2010/main" val="239127220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:\Cytochrome c paper\WB\Amyloid\amyloid data expression\jpg 3.7.22\pirh2 fig 5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3450" y="978932"/>
            <a:ext cx="1819275" cy="146685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 descr="D:\Cytochrome c paper\WB\Amyloid\amyloid data expression\jpg 2.7.22\vdac1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72050" y="733624"/>
            <a:ext cx="2266950" cy="20193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 descr="D:\Cytochrome c paper\WB\Amyloid\amyloid data expression\jpg 2.7.22\t bid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2464832"/>
            <a:ext cx="2914650" cy="2488168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D:\Cytochrome c paper\WB\Amyloid\amyloid data expression\jpg 3.7.22\hsp75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499" y="4694321"/>
            <a:ext cx="2143125" cy="1984375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D:\Cytochrome c paper\WB\Amyloid\amyloid data expression\jpg 2.7.22\hk1.jpg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9341" y="4832866"/>
            <a:ext cx="2371725" cy="198247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D:\Cytochrome c paper\WB\Amyloid\amyloid data expression\jpg 2.7.22\actin 3 fig 5.jpg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48400" y="4724400"/>
            <a:ext cx="2209800" cy="2073910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Rectangle 7"/>
          <p:cNvSpPr/>
          <p:nvPr/>
        </p:nvSpPr>
        <p:spPr>
          <a:xfrm>
            <a:off x="4061766" y="4495800"/>
            <a:ext cx="14205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Hexokinase 1</a:t>
            </a:r>
          </a:p>
        </p:txBody>
      </p:sp>
      <p:sp>
        <p:nvSpPr>
          <p:cNvPr id="9" name="Rectangle 8"/>
          <p:cNvSpPr/>
          <p:nvPr/>
        </p:nvSpPr>
        <p:spPr>
          <a:xfrm>
            <a:off x="6828934" y="4495800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0" name="Rectangle 9"/>
          <p:cNvSpPr/>
          <p:nvPr/>
        </p:nvSpPr>
        <p:spPr>
          <a:xfrm>
            <a:off x="1419225" y="4495800"/>
            <a:ext cx="8274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Hsp75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372597" y="2819400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t-Bid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638800" y="402392"/>
            <a:ext cx="8272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VDAC1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847850" y="381000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176859" y="0"/>
            <a:ext cx="157574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5 (f)  </a:t>
            </a:r>
            <a:endParaRPr lang="en-US" dirty="0"/>
          </a:p>
          <a:p>
            <a:r>
              <a:rPr lang="en-US" dirty="0"/>
              <a:t>Amyloid</a:t>
            </a:r>
            <a:r>
              <a:rPr lang="en-US" baseline="-25000" dirty="0"/>
              <a:t>1-42 </a:t>
            </a:r>
            <a:r>
              <a:rPr lang="en-US" dirty="0"/>
              <a:t>data</a:t>
            </a:r>
          </a:p>
        </p:txBody>
      </p:sp>
      <p:pic>
        <p:nvPicPr>
          <p:cNvPr id="2050" name="Picture 2" descr="D:\sirna\2.3.23\5.3.23\JEpg\fig Vdac112 actin 4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01376" y="932855"/>
            <a:ext cx="2038350" cy="16208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D:\sirna\2.3.23\5.3.23\JEpg\Fig 5 tbid27 actin 6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4615" y="2731532"/>
            <a:ext cx="2106613" cy="18748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Rectangle 16"/>
          <p:cNvSpPr/>
          <p:nvPr/>
        </p:nvSpPr>
        <p:spPr>
          <a:xfrm>
            <a:off x="3657109" y="2895600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8" name="Rectangle 17"/>
          <p:cNvSpPr/>
          <p:nvPr/>
        </p:nvSpPr>
        <p:spPr>
          <a:xfrm>
            <a:off x="7848109" y="478592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23" name="Rectangle 22"/>
          <p:cNvSpPr/>
          <p:nvPr/>
        </p:nvSpPr>
        <p:spPr>
          <a:xfrm>
            <a:off x="3457470" y="402392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1330" y="982361"/>
            <a:ext cx="1950720" cy="15605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508924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" y="152400"/>
            <a:ext cx="12112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</a:t>
            </a:r>
            <a:r>
              <a:rPr lang="en-US" b="1" dirty="0" smtClean="0"/>
              <a:t>6(b)</a:t>
            </a:r>
            <a:endParaRPr lang="en-US" dirty="0"/>
          </a:p>
        </p:txBody>
      </p:sp>
      <p:pic>
        <p:nvPicPr>
          <p:cNvPr id="3" name="Picture 2" descr="G:\coip in vivo compile\19.5.19\jpg 19.5.19\syp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8273" y="1295400"/>
            <a:ext cx="2334260" cy="1838325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 descr="C:\Users\Acer\Desktop\Pirh2 coip.jpg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2" t="5565" r="4257" b="7225"/>
          <a:stretch/>
        </p:blipFill>
        <p:spPr bwMode="auto">
          <a:xfrm>
            <a:off x="3886200" y="1712768"/>
            <a:ext cx="2638425" cy="1695450"/>
          </a:xfrm>
          <a:prstGeom prst="rect">
            <a:avLst/>
          </a:prstGeom>
          <a:noFill/>
          <a:ln w="25400">
            <a:noFill/>
          </a:ln>
          <a:extLst/>
        </p:spPr>
      </p:pic>
      <p:sp>
        <p:nvSpPr>
          <p:cNvPr id="5" name="Rectangle 4"/>
          <p:cNvSpPr/>
          <p:nvPr/>
        </p:nvSpPr>
        <p:spPr>
          <a:xfrm>
            <a:off x="1447800" y="1307068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Cytochrome c 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4735015" y="1295400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pic>
        <p:nvPicPr>
          <p:cNvPr id="8" name="Picture 7" descr="C:\Users\Acer\Desktop\win 2021-12-25 16hr 24min_Exposure_50.0sec.jpg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4" t="2803" r="3057" b="1422"/>
          <a:stretch/>
        </p:blipFill>
        <p:spPr bwMode="auto">
          <a:xfrm>
            <a:off x="296222" y="4191001"/>
            <a:ext cx="2063354" cy="838200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9" name="Picture 8" descr="C:\Users\Acer\Desktop\win 2020-04-04 11hr 25min_Exposure_25.6sec.jpg"/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7" t="1980" r="5120" b="4364"/>
          <a:stretch/>
        </p:blipFill>
        <p:spPr bwMode="auto">
          <a:xfrm>
            <a:off x="2279782" y="3893128"/>
            <a:ext cx="3352800" cy="1433945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10" name="Picture 9" descr="D:\Exp. results\Co-IP\co ip in vitro\12.1.21\input\actin\input actin.jpg"/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2" t="617" r="6228" b="4381"/>
          <a:stretch/>
        </p:blipFill>
        <p:spPr bwMode="auto">
          <a:xfrm>
            <a:off x="5556382" y="3143250"/>
            <a:ext cx="3740018" cy="2190750"/>
          </a:xfrm>
          <a:prstGeom prst="rect">
            <a:avLst/>
          </a:prstGeom>
          <a:noFill/>
          <a:ln w="25400">
            <a:noFill/>
          </a:ln>
          <a:extLst/>
        </p:spPr>
      </p:pic>
      <p:sp>
        <p:nvSpPr>
          <p:cNvPr id="11" name="Rectangle 10"/>
          <p:cNvSpPr/>
          <p:nvPr/>
        </p:nvSpPr>
        <p:spPr>
          <a:xfrm>
            <a:off x="450982" y="3244334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Input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19994" y="3810000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chrome c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4119197" y="3810000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sp>
        <p:nvSpPr>
          <p:cNvPr id="14" name="Rectangle 13"/>
          <p:cNvSpPr/>
          <p:nvPr/>
        </p:nvSpPr>
        <p:spPr>
          <a:xfrm>
            <a:off x="6752649" y="3821668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9243356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2400" y="164068"/>
            <a:ext cx="12368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</a:t>
            </a:r>
            <a:r>
              <a:rPr lang="en-US" b="1" dirty="0" smtClean="0"/>
              <a:t>6 (c</a:t>
            </a:r>
            <a:r>
              <a:rPr lang="en-US" b="1" dirty="0"/>
              <a:t>)</a:t>
            </a:r>
            <a:endParaRPr lang="en-US" dirty="0"/>
          </a:p>
        </p:txBody>
      </p:sp>
      <p:pic>
        <p:nvPicPr>
          <p:cNvPr id="3" name="Picture 2" descr="G:\abhi\revision cells\coip cell\jpg\Pirh2 cytosol 7.jpg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8" t="23305" r="2648" b="24856"/>
          <a:stretch/>
        </p:blipFill>
        <p:spPr bwMode="auto">
          <a:xfrm>
            <a:off x="533400" y="762000"/>
            <a:ext cx="2819400" cy="2286000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4" name="Picture 3" descr="D:\Exp. results\Co-IP\coip in vivo\16.4.19\JEP coip\ptau.jpg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4" t="19063" r="6605" b="4047"/>
          <a:stretch/>
        </p:blipFill>
        <p:spPr bwMode="auto">
          <a:xfrm>
            <a:off x="3352800" y="748145"/>
            <a:ext cx="2683510" cy="1676400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6" name="Picture 5" descr="D:\Exp. results\Co-IP\coip in vivo\19.5.19 coip\input\Jepg\pirh2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6600" y="2781300"/>
            <a:ext cx="3419475" cy="25527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D:\Exp. results\Western Blot\Western blot\STZ\21 day STZ data\1.2.19\JPG\actin.jpg"/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34" t="16674" r="6138" b="12971"/>
          <a:stretch/>
        </p:blipFill>
        <p:spPr bwMode="auto">
          <a:xfrm>
            <a:off x="6572250" y="3581400"/>
            <a:ext cx="2571750" cy="1981200"/>
          </a:xfrm>
          <a:prstGeom prst="rect">
            <a:avLst/>
          </a:prstGeom>
          <a:noFill/>
          <a:ln w="25400">
            <a:noFill/>
          </a:ln>
          <a:extLst/>
        </p:spPr>
      </p:pic>
      <p:sp>
        <p:nvSpPr>
          <p:cNvPr id="8" name="Rectangle 7"/>
          <p:cNvSpPr/>
          <p:nvPr/>
        </p:nvSpPr>
        <p:spPr>
          <a:xfrm>
            <a:off x="990600" y="990600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Cytochrome c 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4572000" y="1066800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973015" y="2895600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sp>
        <p:nvSpPr>
          <p:cNvPr id="12" name="Rectangle 11"/>
          <p:cNvSpPr/>
          <p:nvPr/>
        </p:nvSpPr>
        <p:spPr>
          <a:xfrm>
            <a:off x="6606467" y="2907268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3" name="Rectangle 12"/>
          <p:cNvSpPr/>
          <p:nvPr/>
        </p:nvSpPr>
        <p:spPr>
          <a:xfrm>
            <a:off x="228600" y="2438400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Input</a:t>
            </a:r>
          </a:p>
        </p:txBody>
      </p:sp>
      <p:pic>
        <p:nvPicPr>
          <p:cNvPr id="1026" name="Picture 2" descr="D:\GRP78 paper\Western blot\Western blot GRP78\coip\Invivo\input\jpg 15.4.18\cas 3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1673" y="3395813"/>
            <a:ext cx="3200400" cy="30049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Rectangle 9"/>
          <p:cNvSpPr/>
          <p:nvPr/>
        </p:nvSpPr>
        <p:spPr>
          <a:xfrm>
            <a:off x="373812" y="2895600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chrome c </a:t>
            </a:r>
          </a:p>
        </p:txBody>
      </p:sp>
    </p:spTree>
    <p:extLst>
      <p:ext uri="{BB962C8B-B14F-4D97-AF65-F5344CB8AC3E}">
        <p14:creationId xmlns:p14="http://schemas.microsoft.com/office/powerpoint/2010/main" val="14174845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" y="164068"/>
            <a:ext cx="12112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6(d)</a:t>
            </a:r>
            <a:endParaRPr lang="en-US" dirty="0"/>
          </a:p>
        </p:txBody>
      </p:sp>
      <p:pic>
        <p:nvPicPr>
          <p:cNvPr id="3" name="Picture 2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1" y="1219200"/>
            <a:ext cx="1676400" cy="870267"/>
          </a:xfrm>
          <a:prstGeom prst="rect">
            <a:avLst/>
          </a:prstGeom>
          <a:noFill/>
          <a:ln>
            <a:noFill/>
          </a:ln>
          <a:effectLst/>
          <a:extLst/>
        </p:spPr>
      </p:pic>
      <p:pic>
        <p:nvPicPr>
          <p:cNvPr id="4" name="Picture 3" descr="G:\coip jpg 18.7.22\jpg 9.7.22 fag\coip cyto ov.jpg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604" t="1157" r="7788" b="10815"/>
          <a:stretch/>
        </p:blipFill>
        <p:spPr bwMode="auto">
          <a:xfrm>
            <a:off x="3797300" y="626268"/>
            <a:ext cx="2298700" cy="2056130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5" name="Picture 4" descr="G:\coip jpg 18.7.22\jpg 9.7.22 fag\flag.jpg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99" t="30199" r="28594" b="32355"/>
          <a:stretch/>
        </p:blipFill>
        <p:spPr bwMode="auto">
          <a:xfrm>
            <a:off x="571501" y="3419475"/>
            <a:ext cx="2057400" cy="1200150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6" name="Picture 5" descr="G:\abhi\revision cells\Jpg image\wb\cyto c.jpg"/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02" t="35214" r="10869" b="37728"/>
          <a:stretch/>
        </p:blipFill>
        <p:spPr bwMode="auto">
          <a:xfrm>
            <a:off x="3943350" y="3509962"/>
            <a:ext cx="1695450" cy="1019175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7" name="Picture 6" descr="D:\Cytochrome c paper\WB\Amyloid\Pirh2 2.jpg"/>
          <p:cNvPicPr/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98" t="35717" r="10011" b="32027"/>
          <a:stretch/>
        </p:blipFill>
        <p:spPr bwMode="auto">
          <a:xfrm>
            <a:off x="6324600" y="3523818"/>
            <a:ext cx="1847850" cy="1005320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8" name="Picture 7" descr="G:\coip jpg 18.7.22\jpg 9.7.22 fag\actin flag.jpg"/>
          <p:cNvPicPr/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16" t="38942" r="27732" b="37180"/>
          <a:stretch/>
        </p:blipFill>
        <p:spPr bwMode="auto">
          <a:xfrm>
            <a:off x="304800" y="5314950"/>
            <a:ext cx="2324101" cy="1009650"/>
          </a:xfrm>
          <a:prstGeom prst="rect">
            <a:avLst/>
          </a:prstGeom>
          <a:noFill/>
          <a:ln w="25400">
            <a:noFill/>
          </a:ln>
          <a:extLst/>
        </p:spPr>
      </p:pic>
      <p:sp>
        <p:nvSpPr>
          <p:cNvPr id="9" name="Rectangle 8"/>
          <p:cNvSpPr/>
          <p:nvPr/>
        </p:nvSpPr>
        <p:spPr>
          <a:xfrm>
            <a:off x="990600" y="990600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Cytochrome c 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4572000" y="1066800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312427" y="3193018"/>
            <a:ext cx="6687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Flag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3955212" y="3181350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chrome c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6781800" y="3181350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Pirh2</a:t>
            </a:r>
          </a:p>
        </p:txBody>
      </p:sp>
      <p:sp>
        <p:nvSpPr>
          <p:cNvPr id="14" name="Rectangle 13"/>
          <p:cNvSpPr/>
          <p:nvPr/>
        </p:nvSpPr>
        <p:spPr>
          <a:xfrm>
            <a:off x="1295400" y="4933950"/>
            <a:ext cx="9140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 </a:t>
            </a:r>
          </a:p>
        </p:txBody>
      </p:sp>
      <p:sp>
        <p:nvSpPr>
          <p:cNvPr id="15" name="Rectangle 14"/>
          <p:cNvSpPr/>
          <p:nvPr/>
        </p:nvSpPr>
        <p:spPr>
          <a:xfrm>
            <a:off x="228600" y="2450068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Input</a:t>
            </a:r>
          </a:p>
        </p:txBody>
      </p:sp>
    </p:spTree>
    <p:extLst>
      <p:ext uri="{BB962C8B-B14F-4D97-AF65-F5344CB8AC3E}">
        <p14:creationId xmlns:p14="http://schemas.microsoft.com/office/powerpoint/2010/main" val="204203534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985" y="87868"/>
            <a:ext cx="12032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6(e)</a:t>
            </a:r>
            <a:endParaRPr lang="en-US" dirty="0"/>
          </a:p>
        </p:txBody>
      </p:sp>
      <p:pic>
        <p:nvPicPr>
          <p:cNvPr id="3" name="Picture 2" descr="G:\abhi\revision cells\coip cell\jpg\cyto c cytosol 1.jpg"/>
          <p:cNvPicPr/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200000"/>
                    </a14:imgEffect>
                    <a14:imgEffect>
                      <a14:brightnessContrast brigh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22" t="10906" r="533" b="43114"/>
          <a:stretch/>
        </p:blipFill>
        <p:spPr bwMode="auto">
          <a:xfrm>
            <a:off x="769992" y="533400"/>
            <a:ext cx="2771775" cy="1066800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4" name="Picture 3" descr="G:\coip jpg 18.7.22\jpg 13.6.22\pirh2.jpg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143" t="45706" r="-1128" b="3408"/>
          <a:stretch/>
        </p:blipFill>
        <p:spPr bwMode="auto">
          <a:xfrm>
            <a:off x="4343400" y="810491"/>
            <a:ext cx="2819400" cy="914400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6" name="Picture 5" descr="D:\GRP78 paper\Western blot\Western blot GRP78\WB\gadd 2.jpg"/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85" t="25038" r="11799" b="23455"/>
          <a:stretch/>
        </p:blipFill>
        <p:spPr bwMode="auto">
          <a:xfrm>
            <a:off x="2895600" y="2486025"/>
            <a:ext cx="2857500" cy="1476375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7" name="Picture 6" descr="H:\sirna\2021\co chp\jpg\actin 2.jpg"/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50" t="33524" r="20131" b="43978"/>
          <a:stretch/>
        </p:blipFill>
        <p:spPr bwMode="auto">
          <a:xfrm>
            <a:off x="5915025" y="2895600"/>
            <a:ext cx="2162175" cy="533400"/>
          </a:xfrm>
          <a:prstGeom prst="rect">
            <a:avLst/>
          </a:prstGeom>
          <a:noFill/>
          <a:ln w="25400">
            <a:noFill/>
          </a:ln>
          <a:extLst/>
        </p:spPr>
      </p:pic>
      <p:sp>
        <p:nvSpPr>
          <p:cNvPr id="8" name="Rectangle 7"/>
          <p:cNvSpPr/>
          <p:nvPr/>
        </p:nvSpPr>
        <p:spPr>
          <a:xfrm>
            <a:off x="990600" y="457200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Cytochrome c 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5420815" y="533400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sp>
        <p:nvSpPr>
          <p:cNvPr id="10" name="Rectangle 9"/>
          <p:cNvSpPr/>
          <p:nvPr/>
        </p:nvSpPr>
        <p:spPr>
          <a:xfrm>
            <a:off x="373812" y="2209800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chrome c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973015" y="2209800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sp>
        <p:nvSpPr>
          <p:cNvPr id="12" name="Rectangle 11"/>
          <p:cNvSpPr/>
          <p:nvPr/>
        </p:nvSpPr>
        <p:spPr>
          <a:xfrm>
            <a:off x="6606467" y="2221468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3" name="Rectangle 12"/>
          <p:cNvSpPr/>
          <p:nvPr/>
        </p:nvSpPr>
        <p:spPr>
          <a:xfrm>
            <a:off x="228600" y="1752600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Input</a:t>
            </a:r>
          </a:p>
        </p:txBody>
      </p:sp>
      <p:sp>
        <p:nvSpPr>
          <p:cNvPr id="14" name="Rectangle 13"/>
          <p:cNvSpPr/>
          <p:nvPr/>
        </p:nvSpPr>
        <p:spPr>
          <a:xfrm>
            <a:off x="0" y="3562350"/>
            <a:ext cx="11649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6(f)</a:t>
            </a:r>
            <a:endParaRPr lang="en-US" dirty="0"/>
          </a:p>
        </p:txBody>
      </p:sp>
      <p:pic>
        <p:nvPicPr>
          <p:cNvPr id="15" name="Picture 14" descr="G:\abhi\revision cells\coip cell\jpg\Pirh2 cytosol.jpg"/>
          <p:cNvPicPr/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516" t="30198" r="2529" b="40483"/>
          <a:stretch/>
        </p:blipFill>
        <p:spPr bwMode="auto">
          <a:xfrm>
            <a:off x="578267" y="4152900"/>
            <a:ext cx="2571750" cy="781050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16" name="Picture 15" descr="D:\Cytochrome c paper\WB\Amyloid\coip jpg 18.7.22\jpg 12.6.22\cyto c.jpg"/>
          <p:cNvPicPr/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92" t="44426" r="1592" b="29734"/>
          <a:stretch/>
        </p:blipFill>
        <p:spPr bwMode="auto">
          <a:xfrm>
            <a:off x="4774846" y="4167187"/>
            <a:ext cx="2809875" cy="657225"/>
          </a:xfrm>
          <a:prstGeom prst="rect">
            <a:avLst/>
          </a:prstGeom>
          <a:noFill/>
          <a:ln w="25400">
            <a:noFill/>
          </a:ln>
          <a:extLst/>
        </p:spPr>
      </p:pic>
      <p:sp>
        <p:nvSpPr>
          <p:cNvPr id="20" name="Rectangle 19"/>
          <p:cNvSpPr/>
          <p:nvPr/>
        </p:nvSpPr>
        <p:spPr>
          <a:xfrm>
            <a:off x="1168817" y="3848100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Cytochrome c </a:t>
            </a:r>
            <a:endParaRPr lang="en-US" dirty="0"/>
          </a:p>
        </p:txBody>
      </p:sp>
      <p:sp>
        <p:nvSpPr>
          <p:cNvPr id="21" name="Rectangle 20"/>
          <p:cNvSpPr/>
          <p:nvPr/>
        </p:nvSpPr>
        <p:spPr>
          <a:xfrm>
            <a:off x="5765446" y="3876675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pic>
        <p:nvPicPr>
          <p:cNvPr id="7170" name="Picture 2" descr="D:\GRP78 paper\Western blot\Western blot GRP78\WB\grp78 (3)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3899" y="4848055"/>
            <a:ext cx="2525214" cy="18862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1" name="Picture 3" descr="G:\2.3.23\15.3.23\input\jpg\8.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1637" y="5065675"/>
            <a:ext cx="2280163" cy="17849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2" name="Picture 4" descr="G:\2.3.23\5.3.23\JEpg\21 actin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5025" y="4821623"/>
            <a:ext cx="1834941" cy="17666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Rectangle 24"/>
          <p:cNvSpPr/>
          <p:nvPr/>
        </p:nvSpPr>
        <p:spPr>
          <a:xfrm>
            <a:off x="134043" y="5040868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Input</a:t>
            </a:r>
          </a:p>
        </p:txBody>
      </p:sp>
      <p:sp>
        <p:nvSpPr>
          <p:cNvPr id="23" name="Rectangle 22"/>
          <p:cNvSpPr/>
          <p:nvPr/>
        </p:nvSpPr>
        <p:spPr>
          <a:xfrm>
            <a:off x="3751681" y="5073536"/>
            <a:ext cx="89651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Pirh2</a:t>
            </a:r>
          </a:p>
        </p:txBody>
      </p:sp>
      <p:sp>
        <p:nvSpPr>
          <p:cNvPr id="24" name="Rectangle 23"/>
          <p:cNvSpPr/>
          <p:nvPr/>
        </p:nvSpPr>
        <p:spPr>
          <a:xfrm>
            <a:off x="6301667" y="5040868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22" name="Rectangle 21"/>
          <p:cNvSpPr/>
          <p:nvPr/>
        </p:nvSpPr>
        <p:spPr>
          <a:xfrm>
            <a:off x="1122599" y="5073536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chrome c </a:t>
            </a:r>
          </a:p>
        </p:txBody>
      </p:sp>
      <p:pic>
        <p:nvPicPr>
          <p:cNvPr id="1026" name="Picture 2" descr="G:\New folder\revision cells\2.12.22\jpg 2.12.22\5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009" y="2548461"/>
            <a:ext cx="2657007" cy="11052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9667996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:\Cytochrome c paper\Redox biology\FRBM new figure\cells\Revised MS\Untitled-1 copy.jpg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3" t="9550" r="2913" b="13115"/>
          <a:stretch/>
        </p:blipFill>
        <p:spPr bwMode="auto">
          <a:xfrm>
            <a:off x="838200" y="914400"/>
            <a:ext cx="2847975" cy="857250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5" name="Picture 4" descr="G:\coip jpg 18.7.22\jpg 9.7.22 fag\cyto c input.jpg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66" t="17320" r="7207" b="24028"/>
          <a:stretch/>
        </p:blipFill>
        <p:spPr bwMode="auto">
          <a:xfrm>
            <a:off x="2743199" y="2980026"/>
            <a:ext cx="3015207" cy="1363374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6" name="Picture 5" descr="G:\coip jpg 18.7.22\jpg 9.7.22 fag\actin.jpg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9" t="56965" r="8453" b="4035"/>
          <a:stretch/>
        </p:blipFill>
        <p:spPr bwMode="auto">
          <a:xfrm>
            <a:off x="5803867" y="3095625"/>
            <a:ext cx="2847975" cy="1247775"/>
          </a:xfrm>
          <a:prstGeom prst="rect">
            <a:avLst/>
          </a:prstGeom>
          <a:noFill/>
          <a:ln w="25400">
            <a:noFill/>
          </a:ln>
          <a:extLst/>
        </p:spPr>
      </p:pic>
      <p:sp>
        <p:nvSpPr>
          <p:cNvPr id="7" name="Rectangle 6"/>
          <p:cNvSpPr/>
          <p:nvPr/>
        </p:nvSpPr>
        <p:spPr>
          <a:xfrm>
            <a:off x="76200" y="164068"/>
            <a:ext cx="11979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6(g)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990600" y="457200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Cytochrome c 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3973015" y="2686052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sp>
        <p:nvSpPr>
          <p:cNvPr id="12" name="Rectangle 11"/>
          <p:cNvSpPr/>
          <p:nvPr/>
        </p:nvSpPr>
        <p:spPr>
          <a:xfrm>
            <a:off x="6606467" y="2678668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3" name="Rectangle 12"/>
          <p:cNvSpPr/>
          <p:nvPr/>
        </p:nvSpPr>
        <p:spPr>
          <a:xfrm>
            <a:off x="0" y="2297668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Input</a:t>
            </a:r>
          </a:p>
        </p:txBody>
      </p:sp>
      <p:pic>
        <p:nvPicPr>
          <p:cNvPr id="7170" name="Picture 2" descr="G:\2.3.23\15.3.23\Jepg\s6 pirh2 Pirh2 5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1000" y="-36513"/>
            <a:ext cx="3670300" cy="27035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8"/>
          <p:cNvSpPr/>
          <p:nvPr/>
        </p:nvSpPr>
        <p:spPr>
          <a:xfrm>
            <a:off x="5420815" y="533400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pic>
        <p:nvPicPr>
          <p:cNvPr id="2050" name="Picture 2" descr="D:\GRP78 paper\Western blot\Western blot GRP78\coip\Invitro\input\jpg 6.10.20\grp 78 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938" y="2581275"/>
            <a:ext cx="2829661" cy="2371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Rectangle 9"/>
          <p:cNvSpPr/>
          <p:nvPr/>
        </p:nvSpPr>
        <p:spPr>
          <a:xfrm>
            <a:off x="831012" y="2686052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chrome c </a:t>
            </a:r>
          </a:p>
        </p:txBody>
      </p:sp>
    </p:spTree>
    <p:extLst>
      <p:ext uri="{BB962C8B-B14F-4D97-AF65-F5344CB8AC3E}">
        <p14:creationId xmlns:p14="http://schemas.microsoft.com/office/powerpoint/2010/main" val="78371070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:\Cytochrome c paper\Ubiquitination\cyto c1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4387" y="533400"/>
            <a:ext cx="2505075" cy="1870075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 descr="D:\Cytochrome c paper\Ubiquitination\cyto c invivo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6600" y="304800"/>
            <a:ext cx="2505075" cy="1938655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 descr="G:\jpg\cyto c.jpg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6" t="268" r="3364" b="7888"/>
          <a:stretch/>
        </p:blipFill>
        <p:spPr bwMode="auto">
          <a:xfrm>
            <a:off x="5391150" y="228600"/>
            <a:ext cx="3524250" cy="216217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tangle 4"/>
          <p:cNvSpPr/>
          <p:nvPr/>
        </p:nvSpPr>
        <p:spPr>
          <a:xfrm>
            <a:off x="838200" y="609600"/>
            <a:ext cx="4427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(a)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3291050" y="621268"/>
            <a:ext cx="45236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(b)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5747084" y="621268"/>
            <a:ext cx="4251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(c)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0" y="76200"/>
            <a:ext cx="9435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7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152400" y="2907268"/>
            <a:ext cx="1371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Figure </a:t>
            </a:r>
            <a:r>
              <a:rPr lang="en-US" b="1" dirty="0"/>
              <a:t>7(d)</a:t>
            </a:r>
            <a:endParaRPr lang="en-US" dirty="0"/>
          </a:p>
        </p:txBody>
      </p:sp>
      <p:pic>
        <p:nvPicPr>
          <p:cNvPr id="10" name="Picture 9"/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457200" y="4410075"/>
            <a:ext cx="1466850" cy="466725"/>
          </a:xfrm>
          <a:prstGeom prst="rect">
            <a:avLst/>
          </a:prstGeom>
          <a:noFill/>
        </p:spPr>
      </p:pic>
      <p:pic>
        <p:nvPicPr>
          <p:cNvPr id="11" name="Picture 10" descr="C:\Users\Acer\Desktop\pirh2 2.jpg"/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" t="5847" r="1280" b="1605"/>
          <a:stretch/>
        </p:blipFill>
        <p:spPr bwMode="auto">
          <a:xfrm>
            <a:off x="2295524" y="3629025"/>
            <a:ext cx="3495676" cy="1704975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12" name="Picture 11" descr="G:\2.12.22\jpg\Ubiquitination fig 7 d actin.jpg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600" y="3848100"/>
            <a:ext cx="2743200" cy="1943100"/>
          </a:xfrm>
          <a:prstGeom prst="rect">
            <a:avLst/>
          </a:prstGeom>
          <a:noFill/>
          <a:ln>
            <a:noFill/>
          </a:ln>
        </p:spPr>
      </p:pic>
      <p:sp>
        <p:nvSpPr>
          <p:cNvPr id="13" name="Rectangle 12"/>
          <p:cNvSpPr/>
          <p:nvPr/>
        </p:nvSpPr>
        <p:spPr>
          <a:xfrm>
            <a:off x="373812" y="3352800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chrome c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973015" y="3352800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sp>
        <p:nvSpPr>
          <p:cNvPr id="15" name="Rectangle 14"/>
          <p:cNvSpPr/>
          <p:nvPr/>
        </p:nvSpPr>
        <p:spPr>
          <a:xfrm>
            <a:off x="6606467" y="3364468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6" name="Rectangle 15"/>
          <p:cNvSpPr/>
          <p:nvPr/>
        </p:nvSpPr>
        <p:spPr>
          <a:xfrm>
            <a:off x="0" y="2526268"/>
            <a:ext cx="12394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Input Ban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918769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:\Cytochrome c paper\WB\WB\Western blot -Wildtype\Cyto c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990600"/>
            <a:ext cx="2447925" cy="1295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 descr="D:\Exp. results\Co-IP\coip in vivo\19.5.19 coip\input\Jepg\Cas3.jpg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" t="1093" r="-116" b="-1162"/>
          <a:stretch/>
        </p:blipFill>
        <p:spPr bwMode="auto">
          <a:xfrm>
            <a:off x="2794289" y="795337"/>
            <a:ext cx="2876550" cy="1733550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4" name="Picture 3" descr="C:\Users\user\Desktop\cyto  c1\input\actin\actin cyto c input.jpg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96" t="-548" r="444" b="-1437"/>
          <a:stretch/>
        </p:blipFill>
        <p:spPr bwMode="auto">
          <a:xfrm>
            <a:off x="5670839" y="700953"/>
            <a:ext cx="3209925" cy="1800225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5" name="Picture 4" descr="D:\GRP78 paper\Western blot\Western blot GRP78\WB\aha1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188" y="4481511"/>
            <a:ext cx="1943100" cy="595313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G:\abhi\revision cells\Jpg image\wb\Pirh2 ubiquitination fig 7.jpg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95600" y="3676650"/>
            <a:ext cx="2209800" cy="177165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G:\abhi\revision cells\Jpg image\wb\actin in sirna Ubiquitination fig 7.jpg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600" y="3733801"/>
            <a:ext cx="2257425" cy="1941792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Rectangle 7"/>
          <p:cNvSpPr/>
          <p:nvPr/>
        </p:nvSpPr>
        <p:spPr>
          <a:xfrm>
            <a:off x="373812" y="3352800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chrome c </a:t>
            </a:r>
          </a:p>
        </p:txBody>
      </p:sp>
      <p:sp>
        <p:nvSpPr>
          <p:cNvPr id="9" name="Rectangle 8"/>
          <p:cNvSpPr/>
          <p:nvPr/>
        </p:nvSpPr>
        <p:spPr>
          <a:xfrm>
            <a:off x="3973015" y="3352800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sp>
        <p:nvSpPr>
          <p:cNvPr id="10" name="Rectangle 9"/>
          <p:cNvSpPr/>
          <p:nvPr/>
        </p:nvSpPr>
        <p:spPr>
          <a:xfrm>
            <a:off x="6606467" y="3364468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1" name="Rectangle 10"/>
          <p:cNvSpPr/>
          <p:nvPr/>
        </p:nvSpPr>
        <p:spPr>
          <a:xfrm>
            <a:off x="526212" y="381000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chrome c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4125415" y="381000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sp>
        <p:nvSpPr>
          <p:cNvPr id="13" name="Rectangle 12"/>
          <p:cNvSpPr/>
          <p:nvPr/>
        </p:nvSpPr>
        <p:spPr>
          <a:xfrm>
            <a:off x="6758867" y="392668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4" name="Rectangle 13"/>
          <p:cNvSpPr/>
          <p:nvPr/>
        </p:nvSpPr>
        <p:spPr>
          <a:xfrm>
            <a:off x="0" y="2895600"/>
            <a:ext cx="12178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 7(f)</a:t>
            </a:r>
            <a:endParaRPr lang="en-US" dirty="0"/>
          </a:p>
        </p:txBody>
      </p:sp>
      <p:sp>
        <p:nvSpPr>
          <p:cNvPr id="15" name="Rectangle 14"/>
          <p:cNvSpPr/>
          <p:nvPr/>
        </p:nvSpPr>
        <p:spPr>
          <a:xfrm>
            <a:off x="0" y="11668"/>
            <a:ext cx="12032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7(e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435961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6200" y="152400"/>
            <a:ext cx="1295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8 (a)  </a:t>
            </a:r>
            <a:endParaRPr lang="en-US" dirty="0"/>
          </a:p>
          <a:p>
            <a:r>
              <a:rPr lang="en-US" b="1" dirty="0"/>
              <a:t> STZ data</a:t>
            </a:r>
            <a:endParaRPr lang="en-US" dirty="0"/>
          </a:p>
        </p:txBody>
      </p:sp>
      <p:pic>
        <p:nvPicPr>
          <p:cNvPr id="3" name="Picture 2" descr="D:\Cytochrome c paper\WB\WB\pirh2 (3).jpg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67" t="12500"/>
          <a:stretch/>
        </p:blipFill>
        <p:spPr bwMode="auto">
          <a:xfrm>
            <a:off x="1600200" y="60635"/>
            <a:ext cx="2251710" cy="177165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Picture 3" descr="D:\Cytochrome c paper\WB\WB\Bax final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9037" y="152400"/>
            <a:ext cx="2794000" cy="181398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D:\Cytochrome c paper\WB\WB\bcl-2 final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902" y="2039620"/>
            <a:ext cx="2728595" cy="203708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D:\Cytochrome c paper\WB\WB\Cas9 final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76396" y="2297157"/>
            <a:ext cx="2794000" cy="2085975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G:\2.12.22\jpg\8.jpg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4953000"/>
            <a:ext cx="2552700" cy="196977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 descr="D:\Cytochrome c paper\WB\WB\Actin (2).jpg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600" y="4724400"/>
            <a:ext cx="2895600" cy="2163445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Rectangle 8"/>
          <p:cNvSpPr/>
          <p:nvPr/>
        </p:nvSpPr>
        <p:spPr>
          <a:xfrm>
            <a:off x="1752600" y="511752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 </a:t>
            </a:r>
          </a:p>
        </p:txBody>
      </p:sp>
      <p:sp>
        <p:nvSpPr>
          <p:cNvPr id="10" name="Rectangle 9"/>
          <p:cNvSpPr/>
          <p:nvPr/>
        </p:nvSpPr>
        <p:spPr>
          <a:xfrm>
            <a:off x="4529716" y="483177"/>
            <a:ext cx="5704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 smtClean="0"/>
              <a:t>Bax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1211897" y="2508488"/>
            <a:ext cx="5774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Bcl2</a:t>
            </a: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4806980" y="2537425"/>
            <a:ext cx="14414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leaved </a:t>
            </a:r>
            <a:r>
              <a:rPr lang="en-US" dirty="0" err="1"/>
              <a:t>cas</a:t>
            </a:r>
            <a:r>
              <a:rPr lang="en-US" dirty="0"/>
              <a:t> 9</a:t>
            </a:r>
          </a:p>
        </p:txBody>
      </p:sp>
      <p:sp>
        <p:nvSpPr>
          <p:cNvPr id="13" name="Rectangle 12"/>
          <p:cNvSpPr/>
          <p:nvPr/>
        </p:nvSpPr>
        <p:spPr>
          <a:xfrm>
            <a:off x="457200" y="5117068"/>
            <a:ext cx="15714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leaved Parp1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406067" y="5105400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pic>
        <p:nvPicPr>
          <p:cNvPr id="3074" name="Picture 2" descr="D:\sirna\2.3.23\5.3.23\JEpg\bcl 2 stz 12 actin 3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7787" y="3013755"/>
            <a:ext cx="2001837" cy="15541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D:\sirna\2.3.23\5.3.23\JEpg\bax  stz 17 actin 4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8297" y="297667"/>
            <a:ext cx="2547154" cy="20907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D:\sirna\2.3.23\5.3.23\JEpg\cas 9 stz 24 actin 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46118" y="2388383"/>
            <a:ext cx="2265363" cy="19240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Rectangle 17"/>
          <p:cNvSpPr/>
          <p:nvPr/>
        </p:nvSpPr>
        <p:spPr>
          <a:xfrm>
            <a:off x="3124200" y="2514600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9" name="Rectangle 18"/>
          <p:cNvSpPr/>
          <p:nvPr/>
        </p:nvSpPr>
        <p:spPr>
          <a:xfrm>
            <a:off x="7573482" y="2526268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20" name="Rectangle 19"/>
          <p:cNvSpPr/>
          <p:nvPr/>
        </p:nvSpPr>
        <p:spPr>
          <a:xfrm>
            <a:off x="6846118" y="537935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403265380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" y="191869"/>
            <a:ext cx="1752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8(f)</a:t>
            </a:r>
            <a:endParaRPr lang="en-US" dirty="0"/>
          </a:p>
          <a:p>
            <a:r>
              <a:rPr lang="en-US" b="1" dirty="0"/>
              <a:t>Amyloid</a:t>
            </a:r>
            <a:r>
              <a:rPr lang="en-US" b="1" baseline="-25000" dirty="0"/>
              <a:t>1-42</a:t>
            </a:r>
            <a:r>
              <a:rPr lang="en-US" b="1" dirty="0"/>
              <a:t> data</a:t>
            </a:r>
            <a:endParaRPr lang="en-US" dirty="0"/>
          </a:p>
        </p:txBody>
      </p:sp>
      <p:pic>
        <p:nvPicPr>
          <p:cNvPr id="3" name="Picture 2" descr="D:\Cytochrome c paper\WB\Amyloid\amyloid data expression\jpg 2.6.22\pirh2 3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7800" y="193963"/>
            <a:ext cx="3086100" cy="2295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 descr="D:\Cytochrome c paper\WB\Amyloid\amyloid data expression\jpg 3.7.22\bax 2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7625" y="152400"/>
            <a:ext cx="2619375" cy="24765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D:\Cytochrome c paper\WB\Amyloid\amyloid data expression\jpg 24.6.22\bcl 2 Final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2590800"/>
            <a:ext cx="2438400" cy="2362835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D:\Cytochrome c paper\WB\Amyloid\amyloid data expression\jpg 2.7.22\cas  9 2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5090" y="2590800"/>
            <a:ext cx="3505200" cy="2460625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G:\2.12.22\jpg\52.jpg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4667250"/>
            <a:ext cx="2286000" cy="203835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 descr="D:\Cytochrome c paper\WB\Amyloid\amyloid data expression\jpg 2.7.22\actin 6 fig 8.jpg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7916" y="5102225"/>
            <a:ext cx="2722284" cy="1694418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Rectangle 8"/>
          <p:cNvSpPr/>
          <p:nvPr/>
        </p:nvSpPr>
        <p:spPr>
          <a:xfrm>
            <a:off x="2624716" y="602673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 </a:t>
            </a:r>
          </a:p>
        </p:txBody>
      </p:sp>
      <p:sp>
        <p:nvSpPr>
          <p:cNvPr id="10" name="Rectangle 9"/>
          <p:cNvSpPr/>
          <p:nvPr/>
        </p:nvSpPr>
        <p:spPr>
          <a:xfrm>
            <a:off x="4763523" y="602673"/>
            <a:ext cx="5704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 smtClean="0"/>
              <a:t>Bax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1093357" y="2792327"/>
            <a:ext cx="5774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Bcl2</a:t>
            </a: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4806980" y="2754868"/>
            <a:ext cx="14414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leaved </a:t>
            </a:r>
            <a:r>
              <a:rPr lang="en-US" dirty="0" err="1"/>
              <a:t>cas</a:t>
            </a:r>
            <a:r>
              <a:rPr lang="en-US" dirty="0"/>
              <a:t> 9</a:t>
            </a:r>
          </a:p>
        </p:txBody>
      </p:sp>
      <p:sp>
        <p:nvSpPr>
          <p:cNvPr id="13" name="Rectangle 12"/>
          <p:cNvSpPr/>
          <p:nvPr/>
        </p:nvSpPr>
        <p:spPr>
          <a:xfrm>
            <a:off x="562144" y="4964668"/>
            <a:ext cx="15714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leaved Parp1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580707" y="4953000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pic>
        <p:nvPicPr>
          <p:cNvPr id="4098" name="Picture 2" descr="D:\sirna\2.3.23\5.3.23\JEpg\bcl 2 ab 27 actin 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1363" y="2673350"/>
            <a:ext cx="2484437" cy="22796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D:\sirna\2.3.23\5.3.23\JEpg\Bax 2 1 acti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3989" y="254275"/>
            <a:ext cx="2428011" cy="22477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D:\sirna\2.3.23\5.3.23\JEpg\cas 9 ab 5 actin 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05600" y="2976993"/>
            <a:ext cx="2033587" cy="1679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Rectangle 17"/>
          <p:cNvSpPr/>
          <p:nvPr/>
        </p:nvSpPr>
        <p:spPr>
          <a:xfrm>
            <a:off x="2895600" y="2819400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9" name="Rectangle 18"/>
          <p:cNvSpPr/>
          <p:nvPr/>
        </p:nvSpPr>
        <p:spPr>
          <a:xfrm>
            <a:off x="7139867" y="2743200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20" name="Rectangle 19"/>
          <p:cNvSpPr/>
          <p:nvPr/>
        </p:nvSpPr>
        <p:spPr>
          <a:xfrm>
            <a:off x="6553200" y="545068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41110450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2400" y="191869"/>
            <a:ext cx="1447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7 days data </a:t>
            </a:r>
            <a:endParaRPr lang="en-US" dirty="0"/>
          </a:p>
          <a:p>
            <a:r>
              <a:rPr lang="en-US" b="1" dirty="0"/>
              <a:t>Figure 1(h)</a:t>
            </a:r>
            <a:endParaRPr lang="en-US" dirty="0"/>
          </a:p>
        </p:txBody>
      </p:sp>
      <p:pic>
        <p:nvPicPr>
          <p:cNvPr id="3" name="Picture 2" descr="G:\abhi\revision cells\Jpg image\wb\Pirh2 Shsy5y\Pirh2 7 day AB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6300" y="695324"/>
            <a:ext cx="3305175" cy="2549009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 descr="G:\abhi\revision cells\Jpg image\wb\Pirh2 Shsy5y\ptau 7 day AB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00" y="685800"/>
            <a:ext cx="3124200" cy="2558533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G:\abhi\revision cells\Jpg image\wb\tau 7 day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6325" y="2857500"/>
            <a:ext cx="3419475" cy="23241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G:\abhi\revision cells\Jpg image\wb\Pirh2 Shsy5y\Caspase 3 7 day AB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4800" y="2857500"/>
            <a:ext cx="3962400" cy="21717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G:\abhi\revision cells\Jpg image\wb\Pirh2 Shsy5y\Actin 7 days ab.jpg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6325" y="4676775"/>
            <a:ext cx="3419475" cy="2028825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Rectangle 7"/>
          <p:cNvSpPr/>
          <p:nvPr/>
        </p:nvSpPr>
        <p:spPr>
          <a:xfrm>
            <a:off x="2590309" y="4659868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9" name="Rectangle 8"/>
          <p:cNvSpPr/>
          <p:nvPr/>
        </p:nvSpPr>
        <p:spPr>
          <a:xfrm>
            <a:off x="4800600" y="3244334"/>
            <a:ext cx="18790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leaved </a:t>
            </a:r>
            <a:r>
              <a:rPr lang="en-US" dirty="0" err="1"/>
              <a:t>caspase</a:t>
            </a:r>
            <a:r>
              <a:rPr lang="en-US" dirty="0"/>
              <a:t> 3</a:t>
            </a:r>
          </a:p>
        </p:txBody>
      </p:sp>
      <p:sp>
        <p:nvSpPr>
          <p:cNvPr id="10" name="Rectangle 9"/>
          <p:cNvSpPr/>
          <p:nvPr/>
        </p:nvSpPr>
        <p:spPr>
          <a:xfrm>
            <a:off x="2712407" y="3200400"/>
            <a:ext cx="5641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Tau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590800" y="1219200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278674" y="1143000"/>
            <a:ext cx="6860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</a:t>
            </a:r>
            <a:r>
              <a:rPr lang="en-US" dirty="0" err="1" smtClean="0"/>
              <a:t>pTau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846965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32" descr="Description: D:\Cytochrome c paper\WB\Amyloid\ptau 3.jpg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19" t="29100" r="22087" b="27316"/>
          <a:stretch>
            <a:fillRect/>
          </a:stretch>
        </p:blipFill>
        <p:spPr bwMode="auto">
          <a:xfrm>
            <a:off x="1143000" y="800100"/>
            <a:ext cx="2295525" cy="800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6896" y="1015233"/>
            <a:ext cx="1248207" cy="428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79002" y="935614"/>
            <a:ext cx="1257300" cy="5810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48" descr="Description: C:\Users\Acer\Desktop\APP.jpg"/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95" t="34056" r="28181" b="30203"/>
          <a:stretch>
            <a:fillRect/>
          </a:stretch>
        </p:blipFill>
        <p:spPr bwMode="auto">
          <a:xfrm>
            <a:off x="1333499" y="2057400"/>
            <a:ext cx="2105026" cy="7524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8983" y="2133601"/>
            <a:ext cx="1633862" cy="6367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29275" y="2133600"/>
            <a:ext cx="1600200" cy="847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7"/>
          <p:cNvSpPr/>
          <p:nvPr/>
        </p:nvSpPr>
        <p:spPr>
          <a:xfrm>
            <a:off x="1981200" y="609600"/>
            <a:ext cx="7364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 </a:t>
            </a:r>
            <a:r>
              <a:rPr lang="en-US" dirty="0" smtClean="0"/>
              <a:t>p-tau</a:t>
            </a:r>
            <a:endParaRPr lang="en-US" dirty="0"/>
          </a:p>
        </p:txBody>
      </p:sp>
      <p:sp>
        <p:nvSpPr>
          <p:cNvPr id="15" name="Rectangle 14"/>
          <p:cNvSpPr/>
          <p:nvPr/>
        </p:nvSpPr>
        <p:spPr>
          <a:xfrm>
            <a:off x="3831707" y="609600"/>
            <a:ext cx="5441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 </a:t>
            </a:r>
            <a:r>
              <a:rPr lang="en-US" dirty="0" smtClean="0"/>
              <a:t>tau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5224965" y="621268"/>
            <a:ext cx="11758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myloid</a:t>
            </a:r>
            <a:r>
              <a:rPr lang="en-US" b="1" dirty="0"/>
              <a:t> 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2133600" y="1840468"/>
            <a:ext cx="607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APP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429000" y="1764268"/>
            <a:ext cx="18790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leaved </a:t>
            </a:r>
            <a:r>
              <a:rPr lang="en-US" dirty="0" err="1"/>
              <a:t>caspase</a:t>
            </a:r>
            <a:r>
              <a:rPr lang="en-US" dirty="0"/>
              <a:t> 3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890209" y="1752600"/>
            <a:ext cx="891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  <a:r>
              <a:rPr lang="en-US" b="1" dirty="0"/>
              <a:t> </a:t>
            </a:r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76200" y="152400"/>
            <a:ext cx="269548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1(c)</a:t>
            </a:r>
            <a:endParaRPr lang="en-US" dirty="0"/>
          </a:p>
        </p:txBody>
      </p:sp>
      <p:pic>
        <p:nvPicPr>
          <p:cNvPr id="21" name="Picture 20" descr="D:\Exp. results\Western Blot\Western blot\STZ\21 day STZ data\JPG in vivo  STZ 8.3.19\tau p.jpg"/>
          <p:cNvPicPr/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251" t="34408" r="3508" b="3368"/>
          <a:stretch/>
        </p:blipFill>
        <p:spPr bwMode="auto">
          <a:xfrm>
            <a:off x="135052" y="4129520"/>
            <a:ext cx="1943100" cy="767207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23" name="Picture 22"/>
          <p:cNvPicPr/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29275" y="4044230"/>
            <a:ext cx="1914526" cy="1028700"/>
          </a:xfrm>
          <a:prstGeom prst="rect">
            <a:avLst/>
          </a:prstGeom>
          <a:noFill/>
          <a:ln>
            <a:noFill/>
          </a:ln>
          <a:effectLst/>
          <a:extLst/>
        </p:spPr>
      </p:pic>
      <p:pic>
        <p:nvPicPr>
          <p:cNvPr id="24" name="Picture 23" descr="D:\Exp. results\Western Blot\Western blot\STZ\21 day STZ data\JPG in vivo  STZ 8.3.19\amyloid b.jpg"/>
          <p:cNvPicPr/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47" t="22235" r="24951" b="5708"/>
          <a:stretch/>
        </p:blipFill>
        <p:spPr bwMode="auto">
          <a:xfrm>
            <a:off x="152400" y="5334000"/>
            <a:ext cx="1837690" cy="1371600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26" name="Picture 25" descr="G:\abhi\revision cells\Jpg image\wb\actin in vivo Supp 2.jpg"/>
          <p:cNvPicPr/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37" t="20106" r="11419" b="17967"/>
          <a:stretch/>
        </p:blipFill>
        <p:spPr bwMode="auto">
          <a:xfrm>
            <a:off x="5682378" y="5489428"/>
            <a:ext cx="1714788" cy="1292814"/>
          </a:xfrm>
          <a:prstGeom prst="rect">
            <a:avLst/>
          </a:prstGeom>
          <a:noFill/>
          <a:ln w="25400">
            <a:noFill/>
          </a:ln>
          <a:extLst/>
        </p:spPr>
      </p:pic>
      <p:sp>
        <p:nvSpPr>
          <p:cNvPr id="27" name="Rectangle 26"/>
          <p:cNvSpPr/>
          <p:nvPr/>
        </p:nvSpPr>
        <p:spPr>
          <a:xfrm>
            <a:off x="685800" y="3713024"/>
            <a:ext cx="7364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 </a:t>
            </a:r>
            <a:r>
              <a:rPr lang="en-US" dirty="0" smtClean="0"/>
              <a:t>p-tau</a:t>
            </a:r>
            <a:endParaRPr lang="en-US" dirty="0"/>
          </a:p>
        </p:txBody>
      </p:sp>
      <p:sp>
        <p:nvSpPr>
          <p:cNvPr id="29" name="Rectangle 28"/>
          <p:cNvSpPr/>
          <p:nvPr/>
        </p:nvSpPr>
        <p:spPr>
          <a:xfrm>
            <a:off x="5682165" y="3724692"/>
            <a:ext cx="11758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myloid</a:t>
            </a:r>
            <a:r>
              <a:rPr lang="en-US" b="1" dirty="0"/>
              <a:t> </a:t>
            </a:r>
            <a:endParaRPr lang="en-US" dirty="0"/>
          </a:p>
        </p:txBody>
      </p:sp>
      <p:sp>
        <p:nvSpPr>
          <p:cNvPr id="30" name="Rectangle 29"/>
          <p:cNvSpPr/>
          <p:nvPr/>
        </p:nvSpPr>
        <p:spPr>
          <a:xfrm>
            <a:off x="838200" y="4943892"/>
            <a:ext cx="607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APP </a:t>
            </a:r>
          </a:p>
        </p:txBody>
      </p:sp>
      <p:sp>
        <p:nvSpPr>
          <p:cNvPr id="32" name="Rectangle 31"/>
          <p:cNvSpPr/>
          <p:nvPr/>
        </p:nvSpPr>
        <p:spPr>
          <a:xfrm>
            <a:off x="5791200" y="5248692"/>
            <a:ext cx="891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  <a:r>
              <a:rPr lang="en-US" b="1" dirty="0"/>
              <a:t> </a:t>
            </a:r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0" y="3419892"/>
            <a:ext cx="27227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2(b)</a:t>
            </a:r>
            <a:endParaRPr lang="en-US" dirty="0"/>
          </a:p>
        </p:txBody>
      </p:sp>
      <p:pic>
        <p:nvPicPr>
          <p:cNvPr id="4099" name="Picture 3" descr="D:\GRP78 paper\Western blot\Western blot GRP78\coip\Invivo\input\jpg 19.5.19\gadd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8193" y="4114800"/>
            <a:ext cx="3640607" cy="27194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21" descr="G:\abhi\revision cells\Jpg image\wb\tau 12.jpg"/>
          <p:cNvPicPr/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6" t="14035" r="-3699" b="9693"/>
          <a:stretch/>
        </p:blipFill>
        <p:spPr bwMode="auto">
          <a:xfrm>
            <a:off x="2552700" y="3733800"/>
            <a:ext cx="2400300" cy="1524000"/>
          </a:xfrm>
          <a:prstGeom prst="rect">
            <a:avLst/>
          </a:prstGeom>
          <a:noFill/>
          <a:ln w="25400">
            <a:noFill/>
          </a:ln>
          <a:extLst/>
        </p:spPr>
      </p:pic>
      <p:sp>
        <p:nvSpPr>
          <p:cNvPr id="31" name="Rectangle 30"/>
          <p:cNvSpPr/>
          <p:nvPr/>
        </p:nvSpPr>
        <p:spPr>
          <a:xfrm>
            <a:off x="2692959" y="5096292"/>
            <a:ext cx="18790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leaved </a:t>
            </a:r>
            <a:r>
              <a:rPr lang="en-US" dirty="0" err="1"/>
              <a:t>caspase</a:t>
            </a:r>
            <a:r>
              <a:rPr lang="en-US" dirty="0"/>
              <a:t> 3</a:t>
            </a:r>
          </a:p>
        </p:txBody>
      </p:sp>
      <p:sp>
        <p:nvSpPr>
          <p:cNvPr id="28" name="Rectangle 27"/>
          <p:cNvSpPr/>
          <p:nvPr/>
        </p:nvSpPr>
        <p:spPr>
          <a:xfrm>
            <a:off x="3189677" y="3581400"/>
            <a:ext cx="5641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 </a:t>
            </a:r>
            <a:r>
              <a:rPr lang="en-US" dirty="0"/>
              <a:t>T</a:t>
            </a:r>
            <a:r>
              <a:rPr lang="en-US" dirty="0" smtClean="0"/>
              <a:t>au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118040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G:\abhi\revision cells\Jpg image\wb\Pirh2 Shsy5y\STZ shsy5y actin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0" y="1219200"/>
            <a:ext cx="1362075" cy="1323975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 descr="G:\abhi\revision cells\Jpg image\wb\Pirh2 Shsy5y\STZ shsy5y pirh2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2800" y="1219200"/>
            <a:ext cx="1543050" cy="1419225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Rectangle 3"/>
          <p:cNvSpPr/>
          <p:nvPr/>
        </p:nvSpPr>
        <p:spPr>
          <a:xfrm>
            <a:off x="381000" y="392668"/>
            <a:ext cx="27131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3(a)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457200" y="2514600"/>
            <a:ext cx="269548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3(c)</a:t>
            </a:r>
            <a:endParaRPr lang="en-US" dirty="0"/>
          </a:p>
        </p:txBody>
      </p:sp>
      <p:pic>
        <p:nvPicPr>
          <p:cNvPr id="6" name="Picture 5" descr="G:\abhi\revision cells\Jpg image\wb\Pirh2 Shsy5y\AB shsy5y actin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8274" y="3124200"/>
            <a:ext cx="1533525" cy="14097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G:\abhi\revision cells\Jpg image\wb\Pirh2 Shsy5y\AB shsy5y pirh2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0509" y="3048000"/>
            <a:ext cx="1685925" cy="1609725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Rectangle 7"/>
          <p:cNvSpPr/>
          <p:nvPr/>
        </p:nvSpPr>
        <p:spPr>
          <a:xfrm>
            <a:off x="1699209" y="3124200"/>
            <a:ext cx="891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  <a:r>
              <a:rPr lang="en-US" b="1" dirty="0"/>
              <a:t> 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3733800" y="3135868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 </a:t>
            </a:r>
            <a:r>
              <a:rPr lang="en-US" dirty="0"/>
              <a:t>Pirh2</a:t>
            </a:r>
          </a:p>
        </p:txBody>
      </p:sp>
      <p:sp>
        <p:nvSpPr>
          <p:cNvPr id="10" name="Rectangle 9"/>
          <p:cNvSpPr/>
          <p:nvPr/>
        </p:nvSpPr>
        <p:spPr>
          <a:xfrm>
            <a:off x="1752600" y="1143000"/>
            <a:ext cx="891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  <a:r>
              <a:rPr lang="en-US" b="1" dirty="0"/>
              <a:t> 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3787191" y="1154668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 </a:t>
            </a:r>
            <a:r>
              <a:rPr lang="en-US" dirty="0"/>
              <a:t>Pirh2</a:t>
            </a:r>
          </a:p>
        </p:txBody>
      </p:sp>
      <p:sp>
        <p:nvSpPr>
          <p:cNvPr id="12" name="Rectangle 11"/>
          <p:cNvSpPr/>
          <p:nvPr/>
        </p:nvSpPr>
        <p:spPr>
          <a:xfrm>
            <a:off x="457200" y="4659868"/>
            <a:ext cx="27131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6(a)</a:t>
            </a:r>
            <a:endParaRPr lang="en-US" dirty="0"/>
          </a:p>
        </p:txBody>
      </p:sp>
      <p:pic>
        <p:nvPicPr>
          <p:cNvPr id="13" name="Picture 12" descr="D:\Exp. results\Co-IP\coip in vivo\19.5.19 coip\Jpeg\pcamkii.jpg"/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8" t="-1396" r="-3024" b="3623"/>
          <a:stretch/>
        </p:blipFill>
        <p:spPr bwMode="auto">
          <a:xfrm>
            <a:off x="718704" y="5179060"/>
            <a:ext cx="2266950" cy="1678940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14" name="Picture 13"/>
          <p:cNvPicPr/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4865" t="-159492" r="-10149" b="-139821"/>
          <a:stretch/>
        </p:blipFill>
        <p:spPr bwMode="auto">
          <a:xfrm>
            <a:off x="3020513" y="5215370"/>
            <a:ext cx="2752725" cy="1647825"/>
          </a:xfrm>
          <a:prstGeom prst="rect">
            <a:avLst/>
          </a:prstGeom>
          <a:noFill/>
          <a:ln w="25400">
            <a:noFill/>
            <a:miter lim="800000"/>
            <a:headEnd/>
            <a:tailEnd/>
          </a:ln>
          <a:effectLst/>
          <a:extLst/>
        </p:spPr>
      </p:pic>
      <p:sp>
        <p:nvSpPr>
          <p:cNvPr id="15" name="Rectangle 14"/>
          <p:cNvSpPr/>
          <p:nvPr/>
        </p:nvSpPr>
        <p:spPr>
          <a:xfrm>
            <a:off x="1839415" y="5421868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sp>
        <p:nvSpPr>
          <p:cNvPr id="16" name="Rectangle 15"/>
          <p:cNvSpPr/>
          <p:nvPr/>
        </p:nvSpPr>
        <p:spPr>
          <a:xfrm>
            <a:off x="3832855" y="5421868"/>
            <a:ext cx="14782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chrome c</a:t>
            </a:r>
          </a:p>
        </p:txBody>
      </p:sp>
    </p:spTree>
    <p:extLst>
      <p:ext uri="{BB962C8B-B14F-4D97-AF65-F5344CB8AC3E}">
        <p14:creationId xmlns:p14="http://schemas.microsoft.com/office/powerpoint/2010/main" val="3045121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:\pendrive 7.12.21\2021\16.9.21\jpg\grp78.jpg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91" t="75963" r="7121" b="931"/>
          <a:stretch/>
        </p:blipFill>
        <p:spPr bwMode="auto">
          <a:xfrm>
            <a:off x="7096835" y="1041169"/>
            <a:ext cx="1882831" cy="771988"/>
          </a:xfrm>
          <a:prstGeom prst="rect">
            <a:avLst/>
          </a:prstGeom>
          <a:noFill/>
          <a:ln w="25400">
            <a:noFill/>
          </a:ln>
          <a:extLst/>
        </p:spPr>
      </p:pic>
      <p:sp>
        <p:nvSpPr>
          <p:cNvPr id="5" name="Rectangle 4"/>
          <p:cNvSpPr/>
          <p:nvPr/>
        </p:nvSpPr>
        <p:spPr>
          <a:xfrm>
            <a:off x="1440612" y="621268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chrome c </a:t>
            </a:r>
          </a:p>
        </p:txBody>
      </p:sp>
      <p:sp>
        <p:nvSpPr>
          <p:cNvPr id="6" name="Rectangle 5"/>
          <p:cNvSpPr/>
          <p:nvPr/>
        </p:nvSpPr>
        <p:spPr>
          <a:xfrm>
            <a:off x="7272840" y="609600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β-actin</a:t>
            </a:r>
            <a:endParaRPr lang="en-US" dirty="0"/>
          </a:p>
        </p:txBody>
      </p:sp>
      <p:sp>
        <p:nvSpPr>
          <p:cNvPr id="17" name="Rectangle 16"/>
          <p:cNvSpPr/>
          <p:nvPr/>
        </p:nvSpPr>
        <p:spPr>
          <a:xfrm>
            <a:off x="7385686" y="4769374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β-actin</a:t>
            </a:r>
            <a:endParaRPr lang="en-US" dirty="0"/>
          </a:p>
        </p:txBody>
      </p:sp>
      <p:sp>
        <p:nvSpPr>
          <p:cNvPr id="20" name="Rectangle 19"/>
          <p:cNvSpPr/>
          <p:nvPr/>
        </p:nvSpPr>
        <p:spPr>
          <a:xfrm>
            <a:off x="323382" y="671837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Input</a:t>
            </a:r>
          </a:p>
        </p:txBody>
      </p:sp>
      <p:pic>
        <p:nvPicPr>
          <p:cNvPr id="5123" name="Picture 3" descr="G:\2.3.23\15.3.23\Jepg\Cyto c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7453" y="2743200"/>
            <a:ext cx="3200147" cy="2514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Rectangle 11"/>
          <p:cNvSpPr/>
          <p:nvPr/>
        </p:nvSpPr>
        <p:spPr>
          <a:xfrm>
            <a:off x="4998710" y="2590800"/>
            <a:ext cx="14782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chrome c</a:t>
            </a:r>
          </a:p>
        </p:txBody>
      </p:sp>
      <p:pic>
        <p:nvPicPr>
          <p:cNvPr id="5126" name="Picture 6" descr="G:\2.3.23\15.3.23\Jepg\Pirh2 4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125" y="2100263"/>
            <a:ext cx="3419475" cy="25479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1066800" y="2667000"/>
            <a:ext cx="675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</a:t>
            </a:r>
          </a:p>
        </p:txBody>
      </p:sp>
      <p:sp>
        <p:nvSpPr>
          <p:cNvPr id="8" name="Rectangle 7"/>
          <p:cNvSpPr/>
          <p:nvPr/>
        </p:nvSpPr>
        <p:spPr>
          <a:xfrm>
            <a:off x="381000" y="1981200"/>
            <a:ext cx="27227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6(b)</a:t>
            </a:r>
            <a:endParaRPr lang="en-US" dirty="0"/>
          </a:p>
        </p:txBody>
      </p:sp>
      <p:pic>
        <p:nvPicPr>
          <p:cNvPr id="22" name="Picture 2" descr="D:\GRP78 paper\Western blot\Western blot GRP78\coip\Invivo\input\jpg s2 16.4.19\p tau 3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6305" y="14072"/>
            <a:ext cx="3460246" cy="24401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 descr="G:\2.3.23\15.3.23\input\jpg\6.3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087" y="3980326"/>
            <a:ext cx="3320662" cy="26378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G:\2.3.23\15.3.23\input\jpg\8.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9783" y="3933434"/>
            <a:ext cx="3505199" cy="28271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/>
          <p:cNvSpPr/>
          <p:nvPr/>
        </p:nvSpPr>
        <p:spPr>
          <a:xfrm>
            <a:off x="4682116" y="621268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Pirh2</a:t>
            </a:r>
          </a:p>
        </p:txBody>
      </p:sp>
      <p:sp>
        <p:nvSpPr>
          <p:cNvPr id="18" name="Rectangle 17"/>
          <p:cNvSpPr/>
          <p:nvPr/>
        </p:nvSpPr>
        <p:spPr>
          <a:xfrm>
            <a:off x="4634668" y="4792991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Pirh2</a:t>
            </a:r>
          </a:p>
        </p:txBody>
      </p:sp>
      <p:pic>
        <p:nvPicPr>
          <p:cNvPr id="15" name="Picture 14" descr="C:\Users\user\Desktop\coip in vivo\16.4.19\input\s2\jpg\actin 2.jpg"/>
          <p:cNvPicPr/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61" t="47088" r="28362" b="24232"/>
          <a:stretch/>
        </p:blipFill>
        <p:spPr bwMode="auto">
          <a:xfrm>
            <a:off x="6555614" y="5299229"/>
            <a:ext cx="2083419" cy="623853"/>
          </a:xfrm>
          <a:prstGeom prst="rect">
            <a:avLst/>
          </a:prstGeom>
          <a:noFill/>
          <a:ln w="25400">
            <a:noFill/>
          </a:ln>
          <a:extLst/>
        </p:spPr>
      </p:pic>
      <p:sp>
        <p:nvSpPr>
          <p:cNvPr id="16" name="Rectangle 15"/>
          <p:cNvSpPr/>
          <p:nvPr/>
        </p:nvSpPr>
        <p:spPr>
          <a:xfrm>
            <a:off x="1142130" y="4805000"/>
            <a:ext cx="153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chrome c </a:t>
            </a:r>
          </a:p>
        </p:txBody>
      </p:sp>
      <p:sp>
        <p:nvSpPr>
          <p:cNvPr id="19" name="Rectangle 18"/>
          <p:cNvSpPr/>
          <p:nvPr/>
        </p:nvSpPr>
        <p:spPr>
          <a:xfrm>
            <a:off x="152400" y="4800600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Input</a:t>
            </a:r>
          </a:p>
        </p:txBody>
      </p:sp>
      <p:sp>
        <p:nvSpPr>
          <p:cNvPr id="21" name="Rectangle 20"/>
          <p:cNvSpPr/>
          <p:nvPr/>
        </p:nvSpPr>
        <p:spPr>
          <a:xfrm>
            <a:off x="381000" y="158234"/>
            <a:ext cx="27131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6(a)</a:t>
            </a:r>
            <a:endParaRPr lang="en-US" dirty="0"/>
          </a:p>
        </p:txBody>
      </p:sp>
      <p:pic>
        <p:nvPicPr>
          <p:cNvPr id="1026" name="Picture 2" descr="C:\Users\Acer\Desktop\Untitled-1 copy.jpg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0217" y="992295"/>
            <a:ext cx="1813983" cy="9889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106995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2400" y="0"/>
            <a:ext cx="146165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 </a:t>
            </a:r>
          </a:p>
          <a:p>
            <a:r>
              <a:rPr lang="en-US" b="1" dirty="0"/>
              <a:t>21 days data </a:t>
            </a:r>
            <a:endParaRPr lang="en-US" dirty="0"/>
          </a:p>
          <a:p>
            <a:r>
              <a:rPr lang="en-US" b="1" dirty="0"/>
              <a:t>Figure 1(m)</a:t>
            </a:r>
            <a:endParaRPr lang="en-US" dirty="0"/>
          </a:p>
        </p:txBody>
      </p:sp>
      <p:pic>
        <p:nvPicPr>
          <p:cNvPr id="3" name="Picture 2" descr="G:\amyloid\JPG\Pirh2 53.jpg"/>
          <p:cNvPicPr/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967" t="-2697" r="25411" b="17820"/>
          <a:stretch/>
        </p:blipFill>
        <p:spPr bwMode="auto">
          <a:xfrm>
            <a:off x="533399" y="762000"/>
            <a:ext cx="3324225" cy="1962150"/>
          </a:xfrm>
          <a:prstGeom prst="rect">
            <a:avLst/>
          </a:prstGeom>
          <a:noFill/>
          <a:ln w="25400">
            <a:noFill/>
          </a:ln>
          <a:extLst/>
        </p:spPr>
      </p:pic>
      <p:pic>
        <p:nvPicPr>
          <p:cNvPr id="4" name="Picture 3" descr="C:\Users\Acer\Desktop\ptau 21 ab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7625" y="1066800"/>
            <a:ext cx="2619375" cy="20193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G:\abhi\revision cells\Jpg image\wb\tau 21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0550" y="2819400"/>
            <a:ext cx="3219450" cy="1914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G:\abhi\revision cells\Jpg image\wb\Pirh2 Shsy5y\caspase 3 21 ab.jpg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5200" y="2724150"/>
            <a:ext cx="3886200" cy="215265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G:\abhi\revision cells\Jpg image\wb\actin 1.jpg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4419600"/>
            <a:ext cx="3352800" cy="2057399"/>
          </a:xfrm>
          <a:prstGeom prst="rect">
            <a:avLst/>
          </a:prstGeom>
          <a:noFill/>
          <a:extLst/>
        </p:spPr>
      </p:pic>
      <p:sp>
        <p:nvSpPr>
          <p:cNvPr id="8" name="Rectangle 7"/>
          <p:cNvSpPr/>
          <p:nvPr/>
        </p:nvSpPr>
        <p:spPr>
          <a:xfrm>
            <a:off x="1676400" y="4659868"/>
            <a:ext cx="891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β-actin</a:t>
            </a:r>
          </a:p>
        </p:txBody>
      </p:sp>
      <p:sp>
        <p:nvSpPr>
          <p:cNvPr id="9" name="Rectangle 8"/>
          <p:cNvSpPr/>
          <p:nvPr/>
        </p:nvSpPr>
        <p:spPr>
          <a:xfrm>
            <a:off x="1851609" y="2667000"/>
            <a:ext cx="89159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 </a:t>
            </a:r>
            <a:endParaRPr lang="en-US" dirty="0"/>
          </a:p>
          <a:p>
            <a:r>
              <a:rPr lang="en-US" dirty="0"/>
              <a:t>                                   Tau </a:t>
            </a:r>
          </a:p>
        </p:txBody>
      </p:sp>
      <p:sp>
        <p:nvSpPr>
          <p:cNvPr id="10" name="Rectangle 9"/>
          <p:cNvSpPr/>
          <p:nvPr/>
        </p:nvSpPr>
        <p:spPr>
          <a:xfrm>
            <a:off x="4572000" y="3124200"/>
            <a:ext cx="19066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Cleaved </a:t>
            </a:r>
            <a:r>
              <a:rPr lang="en-US" dirty="0" err="1" smtClean="0"/>
              <a:t>Caspase</a:t>
            </a:r>
            <a:r>
              <a:rPr lang="en-US" dirty="0" smtClean="0"/>
              <a:t> </a:t>
            </a:r>
            <a:r>
              <a:rPr lang="en-US" dirty="0"/>
              <a:t>3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524000" y="1219200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310478" y="1219200"/>
            <a:ext cx="6331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pTau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16977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12771" y="240268"/>
            <a:ext cx="12112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1(q)</a:t>
            </a:r>
            <a:endParaRPr lang="en-US" dirty="0"/>
          </a:p>
        </p:txBody>
      </p:sp>
      <p:pic>
        <p:nvPicPr>
          <p:cNvPr id="3" name="Picture 2" descr="G:\abhi\revision cells\Jpg image\wb\Pirh2 Shsy5y\Pirh2 STZ cells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1025" y="1295400"/>
            <a:ext cx="1885950" cy="1827530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 descr="G:\abhi\revision cells\Jpg image\wb\Pirh2 Shsy5y\actin stz cells.jpg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8509" y="1371600"/>
            <a:ext cx="1295891" cy="178625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tangle 4"/>
          <p:cNvSpPr/>
          <p:nvPr/>
        </p:nvSpPr>
        <p:spPr>
          <a:xfrm>
            <a:off x="1066800" y="1219200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 </a:t>
            </a:r>
          </a:p>
        </p:txBody>
      </p:sp>
      <p:sp>
        <p:nvSpPr>
          <p:cNvPr id="6" name="Rectangle 5"/>
          <p:cNvSpPr/>
          <p:nvPr/>
        </p:nvSpPr>
        <p:spPr>
          <a:xfrm>
            <a:off x="3581400" y="1219200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7" name="Rectangle 6"/>
          <p:cNvSpPr/>
          <p:nvPr/>
        </p:nvSpPr>
        <p:spPr>
          <a:xfrm>
            <a:off x="725831" y="3364468"/>
            <a:ext cx="11791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1(s)</a:t>
            </a:r>
            <a:endParaRPr lang="en-US" dirty="0"/>
          </a:p>
        </p:txBody>
      </p:sp>
      <p:pic>
        <p:nvPicPr>
          <p:cNvPr id="8" name="Picture 7" descr="G:\Cyto c\WB\WB\Western  blot\Pirh2 2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4038600"/>
            <a:ext cx="3848345" cy="2438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Picture 8" descr="D:\Exp. results\Western Blot\Western blot\STZ\21 day STZ data\JPG in vivo  STZ 8.3.19\actin a.jpg"/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0" t="1121" r="-1510" b="-2921"/>
          <a:stretch/>
        </p:blipFill>
        <p:spPr bwMode="auto">
          <a:xfrm>
            <a:off x="3605213" y="4114800"/>
            <a:ext cx="3862387" cy="2209800"/>
          </a:xfrm>
          <a:prstGeom prst="rect">
            <a:avLst/>
          </a:prstGeom>
          <a:noFill/>
          <a:ln w="25400">
            <a:noFill/>
          </a:ln>
          <a:extLst/>
        </p:spPr>
      </p:pic>
      <p:sp>
        <p:nvSpPr>
          <p:cNvPr id="10" name="Rectangle 9"/>
          <p:cNvSpPr/>
          <p:nvPr/>
        </p:nvSpPr>
        <p:spPr>
          <a:xfrm>
            <a:off x="1600200" y="4419600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4800109" y="4431268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12609400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" y="228600"/>
            <a:ext cx="1371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2 (b)</a:t>
            </a:r>
            <a:endParaRPr lang="en-US" dirty="0"/>
          </a:p>
          <a:p>
            <a:r>
              <a:rPr lang="en-US" b="1" dirty="0"/>
              <a:t>STZ data</a:t>
            </a:r>
            <a:endParaRPr lang="en-US" dirty="0"/>
          </a:p>
        </p:txBody>
      </p:sp>
      <p:pic>
        <p:nvPicPr>
          <p:cNvPr id="3" name="Picture 2" descr="G:\cas 3\Figure 2 Pirh2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1143000"/>
            <a:ext cx="2423795" cy="1809750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 descr="D:\Cytochrome c paper\WB\WB\Amyloid final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2762" y="1076960"/>
            <a:ext cx="2886075" cy="215392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D:\Cytochrome c paper\WB\WB\p-Tau Exp 1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1136073"/>
            <a:ext cx="2571750" cy="1919605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G:\abhi\revision cells\Jpg image\wb\tau STZ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3120" y="3886200"/>
            <a:ext cx="1971675" cy="1635125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D:\Cytochrome c paper\WB\WB\cleaved cas 3 final.jpg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2761" y="3652058"/>
            <a:ext cx="2886075" cy="1986742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 descr="D:\Cytochrome c paper\WB\WB\actin 2 (2).jpg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8530" y="3505200"/>
            <a:ext cx="3049270" cy="2276475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Rectangle 8"/>
          <p:cNvSpPr/>
          <p:nvPr/>
        </p:nvSpPr>
        <p:spPr>
          <a:xfrm>
            <a:off x="1524000" y="1002268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Pirh2 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4010532" y="990600"/>
            <a:ext cx="11229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myloid</a:t>
            </a:r>
          </a:p>
        </p:txBody>
      </p:sp>
      <p:sp>
        <p:nvSpPr>
          <p:cNvPr id="11" name="Rectangle 10"/>
          <p:cNvSpPr/>
          <p:nvPr/>
        </p:nvSpPr>
        <p:spPr>
          <a:xfrm>
            <a:off x="7107474" y="990600"/>
            <a:ext cx="6649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 smtClean="0"/>
              <a:t>ptau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1645607" y="3364468"/>
            <a:ext cx="5641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Tau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3618694" y="3244334"/>
            <a:ext cx="19066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leaved </a:t>
            </a:r>
            <a:r>
              <a:rPr lang="en-US" dirty="0" err="1"/>
              <a:t>Caspase</a:t>
            </a:r>
            <a:r>
              <a:rPr lang="en-US" dirty="0"/>
              <a:t> 3</a:t>
            </a:r>
          </a:p>
        </p:txBody>
      </p:sp>
      <p:sp>
        <p:nvSpPr>
          <p:cNvPr id="15" name="Rectangle 14"/>
          <p:cNvSpPr/>
          <p:nvPr/>
        </p:nvSpPr>
        <p:spPr>
          <a:xfrm>
            <a:off x="6933709" y="3244334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40987883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2400" y="152400"/>
            <a:ext cx="1905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2 (g)</a:t>
            </a:r>
            <a:endParaRPr lang="en-US" dirty="0"/>
          </a:p>
          <a:p>
            <a:r>
              <a:rPr lang="en-US" b="1" dirty="0"/>
              <a:t>Amyloid </a:t>
            </a:r>
            <a:r>
              <a:rPr lang="en-US" b="1" baseline="-25000" dirty="0"/>
              <a:t>1-42</a:t>
            </a:r>
            <a:r>
              <a:rPr lang="en-US" b="1" dirty="0"/>
              <a:t> data</a:t>
            </a:r>
            <a:endParaRPr lang="en-US" dirty="0"/>
          </a:p>
        </p:txBody>
      </p:sp>
      <p:pic>
        <p:nvPicPr>
          <p:cNvPr id="3" name="Picture 2" descr="D:\Cytochrome c paper\WB\Amyloid\amyloid data expression\jpg 2.6.22\pirh2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990600"/>
            <a:ext cx="2353310" cy="2200275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 descr="D:\Cytochrome c paper\WB\Amyloid\amyloid data expression\jpg 2.6.22\amyloid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95600" y="798731"/>
            <a:ext cx="2790825" cy="259207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D:\Cytochrome c paper\WB\Amyloid\amyloid data expression\jpg 2.6.22\ptau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992505"/>
            <a:ext cx="2476500" cy="2360295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G:\abhi\revision cells\Jpg image\wb\tau AB 2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0" y="3156239"/>
            <a:ext cx="1676400" cy="1676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D:\Cytochrome c paper\WB\Amyloid\amyloid data expression\jpg 2.6.22\cas 3.jpg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95600" y="2957195"/>
            <a:ext cx="2819400" cy="1828801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 descr="G:\abhi\revision cells\Jpg image\wb\actin Fig 2 AB.jpg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86425" y="2957195"/>
            <a:ext cx="2009775" cy="1828801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Rectangle 8"/>
          <p:cNvSpPr/>
          <p:nvPr/>
        </p:nvSpPr>
        <p:spPr>
          <a:xfrm>
            <a:off x="1524000" y="1002268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Pirh2 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3733800" y="990600"/>
            <a:ext cx="11229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myloid</a:t>
            </a:r>
          </a:p>
        </p:txBody>
      </p:sp>
      <p:sp>
        <p:nvSpPr>
          <p:cNvPr id="11" name="Rectangle 10"/>
          <p:cNvSpPr/>
          <p:nvPr/>
        </p:nvSpPr>
        <p:spPr>
          <a:xfrm>
            <a:off x="6193074" y="990600"/>
            <a:ext cx="6649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 smtClean="0"/>
              <a:t>ptau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1645607" y="3364468"/>
            <a:ext cx="5641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Tau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3618694" y="3244334"/>
            <a:ext cx="19066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leaved </a:t>
            </a:r>
            <a:r>
              <a:rPr lang="en-US" dirty="0" err="1"/>
              <a:t>Caspase</a:t>
            </a:r>
            <a:r>
              <a:rPr lang="en-US" dirty="0"/>
              <a:t> 3</a:t>
            </a:r>
          </a:p>
        </p:txBody>
      </p:sp>
      <p:sp>
        <p:nvSpPr>
          <p:cNvPr id="14" name="Rectangle 13"/>
          <p:cNvSpPr/>
          <p:nvPr/>
        </p:nvSpPr>
        <p:spPr>
          <a:xfrm>
            <a:off x="6248400" y="3244334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21681065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4800" y="115669"/>
            <a:ext cx="1295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4 (g)</a:t>
            </a:r>
            <a:endParaRPr lang="en-US" dirty="0"/>
          </a:p>
          <a:p>
            <a:r>
              <a:rPr lang="en-US" b="1" dirty="0"/>
              <a:t>STZ data</a:t>
            </a:r>
            <a:endParaRPr lang="en-US" dirty="0"/>
          </a:p>
        </p:txBody>
      </p:sp>
      <p:pic>
        <p:nvPicPr>
          <p:cNvPr id="3" name="Picture 2" descr="D:\Cytochrome c paper\WB\WB\pirh2 4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375" y="990600"/>
            <a:ext cx="2714625" cy="2026285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 descr="G:\abhi\revision cells\Jpg image\wb\gapdh STZ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0975" y="914400"/>
            <a:ext cx="2457450" cy="2200275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D:\Cytochrome c paper\WB\Amyloid\amyloid data expression\jpg 24.6.22\mito  cyto c 2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76975" y="945515"/>
            <a:ext cx="2667000" cy="207137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D:\Cytochrome c paper\WB\Amyloid\amyloid data expression\jpg 24.6.22\cox 4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3114675"/>
            <a:ext cx="2695575" cy="249555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D:\Cytochrome c paper\WB\Amyloid\amyloid data expression\jpg 3.7.22\Cyto c.jpg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8575" y="3428999"/>
            <a:ext cx="2200275" cy="1952625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 descr="D:\Cytochrome c paper\WB\WB\actin Cyto c.jpg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4100" y="3298824"/>
            <a:ext cx="2324100" cy="2082800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Rectangle 8"/>
          <p:cNvSpPr/>
          <p:nvPr/>
        </p:nvSpPr>
        <p:spPr>
          <a:xfrm>
            <a:off x="1857375" y="545068"/>
            <a:ext cx="8382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Pirh2                                                    </a:t>
            </a:r>
          </a:p>
        </p:txBody>
      </p:sp>
      <p:sp>
        <p:nvSpPr>
          <p:cNvPr id="10" name="Rectangle 9"/>
          <p:cNvSpPr/>
          <p:nvPr/>
        </p:nvSpPr>
        <p:spPr>
          <a:xfrm>
            <a:off x="4676775" y="533400"/>
            <a:ext cx="8382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err="1" smtClean="0"/>
              <a:t>Gapdh</a:t>
            </a:r>
            <a:r>
              <a:rPr lang="en-US" dirty="0" smtClean="0"/>
              <a:t>                                                    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6734175" y="457200"/>
            <a:ext cx="156581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Mitochondrial </a:t>
            </a:r>
            <a:endParaRPr lang="en-US" dirty="0" smtClean="0"/>
          </a:p>
          <a:p>
            <a:r>
              <a:rPr lang="en-US" dirty="0" smtClean="0"/>
              <a:t>cytochrome </a:t>
            </a:r>
            <a:r>
              <a:rPr lang="en-US" dirty="0"/>
              <a:t>c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772233" y="3364468"/>
            <a:ext cx="6947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ox 4</a:t>
            </a:r>
          </a:p>
        </p:txBody>
      </p:sp>
      <p:sp>
        <p:nvSpPr>
          <p:cNvPr id="13" name="Rectangle 12"/>
          <p:cNvSpPr/>
          <p:nvPr/>
        </p:nvSpPr>
        <p:spPr>
          <a:xfrm>
            <a:off x="3954249" y="3244334"/>
            <a:ext cx="23989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solic cytochrome c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6939842" y="3244334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40418144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2400" y="152400"/>
            <a:ext cx="2209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4 (j)</a:t>
            </a:r>
            <a:endParaRPr lang="en-US" dirty="0"/>
          </a:p>
          <a:p>
            <a:r>
              <a:rPr lang="en-US" b="1" dirty="0"/>
              <a:t>Amyloid </a:t>
            </a:r>
            <a:r>
              <a:rPr lang="en-US" b="1" baseline="-25000" dirty="0"/>
              <a:t>1-42</a:t>
            </a:r>
            <a:r>
              <a:rPr lang="en-US" b="1" dirty="0"/>
              <a:t> data</a:t>
            </a:r>
            <a:endParaRPr lang="en-US" dirty="0"/>
          </a:p>
        </p:txBody>
      </p:sp>
      <p:pic>
        <p:nvPicPr>
          <p:cNvPr id="3" name="Picture 2" descr="G:\abhi\revision cells\Jpg image\wb\Fig 4 use.jp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576" y="1363027"/>
            <a:ext cx="3095625" cy="2455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 descr="G:\abhi\revision cells\Jpg image\wb\gapdh 4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1800" y="1529714"/>
            <a:ext cx="2971800" cy="2139316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D:\Cytochrome c paper\WB\Amyloid\amyloid data expression\jpg 24.6.22\mito  cyto c 3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4999" y="1676400"/>
            <a:ext cx="2743201" cy="1676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D:\Cytochrome c paper\WB\Amyloid\amyloid data expression\jpg 24.6.22\cox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900" y="3592657"/>
            <a:ext cx="2982116" cy="245745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D:\Cytochrome c paper\WB\Amyloid\amyloid data expression\jpg 24.6.22\cytosolic cyto c 2.jpg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0" y="3716020"/>
            <a:ext cx="3276600" cy="209423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 descr="D:\Cytochrome c paper\WB\Amyloid\amyloid data expression\jpg 24.6.22\actin 2.jpg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1926" y="3733800"/>
            <a:ext cx="3041074" cy="2362200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Rectangle 8"/>
          <p:cNvSpPr/>
          <p:nvPr/>
        </p:nvSpPr>
        <p:spPr>
          <a:xfrm>
            <a:off x="1143000" y="1154668"/>
            <a:ext cx="8382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Pirh2                                                    </a:t>
            </a:r>
          </a:p>
        </p:txBody>
      </p:sp>
      <p:sp>
        <p:nvSpPr>
          <p:cNvPr id="10" name="Rectangle 9"/>
          <p:cNvSpPr/>
          <p:nvPr/>
        </p:nvSpPr>
        <p:spPr>
          <a:xfrm>
            <a:off x="3962400" y="1066800"/>
            <a:ext cx="8382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err="1" smtClean="0"/>
              <a:t>Gapdh</a:t>
            </a:r>
            <a:r>
              <a:rPr lang="en-US" dirty="0" smtClean="0"/>
              <a:t>                                                    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6324600" y="1030069"/>
            <a:ext cx="156581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Mitochondrial </a:t>
            </a:r>
            <a:endParaRPr lang="en-US" dirty="0" smtClean="0"/>
          </a:p>
          <a:p>
            <a:r>
              <a:rPr lang="en-US" dirty="0" smtClean="0"/>
              <a:t>cytochrome </a:t>
            </a:r>
            <a:r>
              <a:rPr lang="en-US" dirty="0"/>
              <a:t>c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143000" y="3364468"/>
            <a:ext cx="6947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ox 4</a:t>
            </a:r>
          </a:p>
        </p:txBody>
      </p:sp>
      <p:sp>
        <p:nvSpPr>
          <p:cNvPr id="13" name="Rectangle 12"/>
          <p:cNvSpPr/>
          <p:nvPr/>
        </p:nvSpPr>
        <p:spPr>
          <a:xfrm>
            <a:off x="3325016" y="3244334"/>
            <a:ext cx="23989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ytosolic cytochrome c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6606467" y="3244334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10741674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:\Cytochrome c paper\WB\WB\pirh2 (4)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6937" y="527963"/>
            <a:ext cx="2284643" cy="1681837"/>
          </a:xfrm>
          <a:prstGeom prst="rect">
            <a:avLst/>
          </a:prstGeom>
          <a:noFill/>
          <a:ln>
            <a:noFill/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2730" y="5137666"/>
            <a:ext cx="1950720" cy="1560576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304800" y="228600"/>
            <a:ext cx="1447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5 (a)</a:t>
            </a:r>
            <a:endParaRPr lang="en-US" dirty="0"/>
          </a:p>
          <a:p>
            <a:r>
              <a:rPr lang="en-US" dirty="0"/>
              <a:t>STZ data</a:t>
            </a:r>
          </a:p>
        </p:txBody>
      </p:sp>
      <p:pic>
        <p:nvPicPr>
          <p:cNvPr id="5" name="Picture 4" descr="D:\Cytochrome c paper\WB\WB\t-bid final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2485073"/>
            <a:ext cx="2714625" cy="2026285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D:\Cytochrome c paper\WB\WB\hsp75 Exp 3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0" y="4842589"/>
            <a:ext cx="2466975" cy="18415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D:\Cytochrome c paper\WB\WB\Hexokinase1 final.jpg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7601" y="4511358"/>
            <a:ext cx="2971800" cy="2346641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Rectangle 8"/>
          <p:cNvSpPr/>
          <p:nvPr/>
        </p:nvSpPr>
        <p:spPr>
          <a:xfrm>
            <a:off x="4471341" y="4820166"/>
            <a:ext cx="14205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Hexokinase 1</a:t>
            </a:r>
          </a:p>
        </p:txBody>
      </p:sp>
      <p:sp>
        <p:nvSpPr>
          <p:cNvPr id="10" name="Rectangle 9"/>
          <p:cNvSpPr/>
          <p:nvPr/>
        </p:nvSpPr>
        <p:spPr>
          <a:xfrm>
            <a:off x="7048745" y="4964668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614488" y="4964668"/>
            <a:ext cx="8274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Hsp75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772647" y="3011776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t-Bid </a:t>
            </a:r>
          </a:p>
        </p:txBody>
      </p:sp>
      <p:grpSp>
        <p:nvGrpSpPr>
          <p:cNvPr id="22" name="Group 21"/>
          <p:cNvGrpSpPr/>
          <p:nvPr/>
        </p:nvGrpSpPr>
        <p:grpSpPr>
          <a:xfrm>
            <a:off x="4543215" y="284708"/>
            <a:ext cx="2647950" cy="2049145"/>
            <a:chOff x="4543215" y="284708"/>
            <a:chExt cx="2647950" cy="2049145"/>
          </a:xfrm>
        </p:grpSpPr>
        <p:pic>
          <p:nvPicPr>
            <p:cNvPr id="4" name="Picture 3" descr="D:\Cytochrome c paper\WB\WB\VDAC1 final.jpg"/>
            <p:cNvPicPr/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43215" y="284708"/>
              <a:ext cx="2647950" cy="204914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3" name="Rectangle 12"/>
            <p:cNvSpPr/>
            <p:nvPr/>
          </p:nvSpPr>
          <p:spPr>
            <a:xfrm>
              <a:off x="5725986" y="468868"/>
              <a:ext cx="82721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/>
                <a:t>VDAC1</a:t>
              </a:r>
            </a:p>
          </p:txBody>
        </p:sp>
      </p:grpSp>
      <p:sp>
        <p:nvSpPr>
          <p:cNvPr id="14" name="Rectangle 13"/>
          <p:cNvSpPr/>
          <p:nvPr/>
        </p:nvSpPr>
        <p:spPr>
          <a:xfrm>
            <a:off x="1828800" y="533400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irh2 </a:t>
            </a:r>
          </a:p>
        </p:txBody>
      </p:sp>
      <p:pic>
        <p:nvPicPr>
          <p:cNvPr id="1026" name="Picture 2" descr="D:\sirna\2.3.23\5.3.23\JEpg\VDAC1 actin STZ Fig 5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79348" y="700712"/>
            <a:ext cx="2189163" cy="17891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Rectangle 15"/>
          <p:cNvSpPr/>
          <p:nvPr/>
        </p:nvSpPr>
        <p:spPr>
          <a:xfrm>
            <a:off x="7334251" y="419985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pic>
        <p:nvPicPr>
          <p:cNvPr id="1027" name="Picture 3" descr="D:\sirna\2.3.23\5.3.23\JEpg\fig 5 t bid 1 actin 5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8525" y="3069908"/>
            <a:ext cx="2493963" cy="22796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Rectangle 17"/>
          <p:cNvSpPr/>
          <p:nvPr/>
        </p:nvSpPr>
        <p:spPr>
          <a:xfrm>
            <a:off x="4191000" y="3075226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9" name="Rectangle 18"/>
          <p:cNvSpPr/>
          <p:nvPr/>
        </p:nvSpPr>
        <p:spPr>
          <a:xfrm>
            <a:off x="4061766" y="4953000"/>
            <a:ext cx="14205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Hexokinase 1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4391" y="630936"/>
            <a:ext cx="2179320" cy="1959864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>
            <a:off x="3682053" y="520975"/>
            <a:ext cx="8386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4244477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9</TotalTime>
  <Words>367</Words>
  <Application>Microsoft Office PowerPoint</Application>
  <PresentationFormat>On-screen Show (4:3)</PresentationFormat>
  <Paragraphs>202</Paragraphs>
  <Slides>2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2</vt:i4>
      </vt:variant>
    </vt:vector>
  </HeadingPairs>
  <TitlesOfParts>
    <vt:vector size="23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cer</dc:creator>
  <cp:lastModifiedBy>Laxman Negi. Singh</cp:lastModifiedBy>
  <cp:revision>76</cp:revision>
  <dcterms:created xsi:type="dcterms:W3CDTF">2006-08-16T00:00:00Z</dcterms:created>
  <dcterms:modified xsi:type="dcterms:W3CDTF">2024-05-06T11:21:05Z</dcterms:modified>
</cp:coreProperties>
</file>